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9" r:id="rId2"/>
    <p:sldId id="258" r:id="rId3"/>
    <p:sldId id="260" r:id="rId4"/>
    <p:sldId id="264" r:id="rId5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93" autoAdjust="0"/>
    <p:restoredTop sz="94660"/>
  </p:normalViewPr>
  <p:slideViewPr>
    <p:cSldViewPr snapToGrid="0" showGuides="1">
      <p:cViewPr varScale="1">
        <p:scale>
          <a:sx n="130" d="100"/>
          <a:sy n="130" d="100"/>
        </p:scale>
        <p:origin x="610" y="65"/>
      </p:cViewPr>
      <p:guideLst>
        <p:guide orient="horz" pos="311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91896C-30DD-4103-AC2A-E8051B6A2A2C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4FC921-BD0F-4E07-868A-900E1DE879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6094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76ADD9-FBF5-4DAE-AD24-9AF332D514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FA178B0-1B58-4504-90A4-67BA792A61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746116-3D71-4472-9530-E436270B6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FBFCFB-2E06-4935-8943-5FC09AC13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FA7F21-5655-41FB-A096-9B85ACF00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631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D69942-FB8A-4AC3-B973-D65A0926D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5B3002A-22B8-4D08-9B04-E752EAAEB7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CDC59C-4437-4CF6-94C4-120E00479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F2873A-50D6-4675-A706-291F89F48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7C25DF-F91E-490D-BCA1-57C21D661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55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2B1705B-6CEA-4C2A-8B97-0EF561D193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729F8BB-7A27-42CE-901C-01BD2A1F3B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A52116-2A15-4600-95E6-B0BEAEB98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E81F78-F1DA-40C3-91AA-6AF6A6901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3B22AB-8150-4E86-B88B-723901C54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548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C00B94-5FE3-43CC-B147-10DE21BDFE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49E878-9DF3-40B5-B716-BE666A1294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659DED-1B24-4C5B-98E9-44F549435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71A2A1-3F48-4123-A478-28F0970D1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633854-6395-4EBC-9FE2-931B297CA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717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494096-3E2C-4A39-BC3A-7AA8CD483D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D49FA11-388A-498F-9C34-FAC55417EE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4B4D65-A092-4293-B39D-D6CD70ED7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A6826A-706A-4ED6-8E98-2C6766294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ECA3C9-DCE8-4ADB-B6FB-7742DF6A6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314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91764C-1E2C-40D4-AB89-12C3F68AA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30C322-DFEF-418D-9CDA-891C765B8F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2F52A7E-5982-4D9F-8D06-72F9420734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875908-2803-4783-9AFA-638A58275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5591B9-332A-4DC8-82DB-EC744568B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D3E6A0-042B-4E42-9604-B2AC660FE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541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3D0D02-343A-4B49-BC36-8AA270BBDF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227826-5F62-4843-A05F-974C36AD1A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637C1C4-2A0D-4F51-A028-6F01A606AB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63B57CC-18F3-41D5-A738-E233C7E44C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91B82F3-0D7F-4753-B7B3-7E7A198E86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B04D100-CA11-4D68-B7B3-541AD17C8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51D4F6E-E4E6-474D-BA22-BF5EA7DCB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94ED890-7EB9-46AF-8B91-E749F51CC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995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8DEC62-BBD5-4898-BDFE-7BD369B44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78D9B41-BA16-4124-B6E2-7FAFF2A4F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510F674-535B-488B-B571-858E615DC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24BFD7E-5D3F-4B5D-9B81-49EF1B95A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293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F60011A-581F-447D-9721-1A3044613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7F43F1E-C215-455A-A6C3-50BBF7370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468471B-495C-4823-9803-DD8232CA6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389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A25FC7-9618-48AC-A82E-766FDFC15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119CCEA-CA51-49AB-B4B9-9301C9B841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1961F11-4AE8-41E7-AB1F-30E2EABC3F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17E7F7-5B7C-4C4D-8840-A21656219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D7833EE-E156-48EA-A0F6-FD9DE2237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4ED97F-AB36-41C2-A9CC-86FCB62D2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256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C9AAB7-80F3-4DCB-BF55-203838203E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4695EF5-428E-4208-A73D-CA40403B81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B56D85A-0002-4DC9-A268-151EC109F5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C026FC-CC4F-4F1E-90D1-3F9EDFC73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4DB873-86BC-4806-8566-34452430E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301E3A7-3968-4665-8584-BF564E074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900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054AC7A-81BD-4158-8D17-B04F279DD2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2C83BC-420A-4572-8CD5-D55CFA3F59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1D8B57-BAAC-4195-95B7-C72F1927F2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93ABA-1C7A-456D-9B3D-046980E05226}" type="datetimeFigureOut">
              <a:rPr kumimoji="1" lang="ja-JP" altLang="en-US" smtClean="0"/>
              <a:t>2022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11CDC0-37DA-46A8-882C-8067B20EE4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971C1D-E17A-4660-AA71-20B438E58F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25F727-0185-437D-BB01-D145E615F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847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274C3892-A3C0-443F-860E-BA433C01144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55503" y="5113502"/>
            <a:ext cx="4519396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2769997B-3452-45C2-8B53-DAA55F274958}"/>
              </a:ext>
            </a:extLst>
          </p:cNvPr>
          <p:cNvSpPr>
            <a:spLocks noChangeShapeType="1"/>
          </p:cNvSpPr>
          <p:nvPr/>
        </p:nvSpPr>
        <p:spPr bwMode="auto">
          <a:xfrm>
            <a:off x="4155503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092234C0-C566-4AEC-9171-C282785697FF}"/>
              </a:ext>
            </a:extLst>
          </p:cNvPr>
          <p:cNvSpPr>
            <a:spLocks noChangeShapeType="1"/>
          </p:cNvSpPr>
          <p:nvPr/>
        </p:nvSpPr>
        <p:spPr bwMode="auto">
          <a:xfrm>
            <a:off x="5053192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E1CA7B9C-0A75-4163-9570-B3D5F2A4EDAB}"/>
              </a:ext>
            </a:extLst>
          </p:cNvPr>
          <p:cNvSpPr>
            <a:spLocks noChangeShapeType="1"/>
          </p:cNvSpPr>
          <p:nvPr/>
        </p:nvSpPr>
        <p:spPr bwMode="auto">
          <a:xfrm>
            <a:off x="5963778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ACE05704-F438-401E-AA38-DD1FF8F79586}"/>
              </a:ext>
            </a:extLst>
          </p:cNvPr>
          <p:cNvSpPr>
            <a:spLocks noChangeShapeType="1"/>
          </p:cNvSpPr>
          <p:nvPr/>
        </p:nvSpPr>
        <p:spPr bwMode="auto">
          <a:xfrm>
            <a:off x="6864045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9DB394D4-0CC9-46AA-A051-142C7FDEFAF9}"/>
              </a:ext>
            </a:extLst>
          </p:cNvPr>
          <p:cNvSpPr>
            <a:spLocks noChangeShapeType="1"/>
          </p:cNvSpPr>
          <p:nvPr/>
        </p:nvSpPr>
        <p:spPr bwMode="auto">
          <a:xfrm>
            <a:off x="7774632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9E6EAF8E-EC26-4C2C-A636-CB5F99BA0274}"/>
              </a:ext>
            </a:extLst>
          </p:cNvPr>
          <p:cNvSpPr>
            <a:spLocks noChangeShapeType="1"/>
          </p:cNvSpPr>
          <p:nvPr/>
        </p:nvSpPr>
        <p:spPr bwMode="auto">
          <a:xfrm>
            <a:off x="8674899" y="5113502"/>
            <a:ext cx="0" cy="6511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F43509C-2E4D-4E61-AA34-06693B0A44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0697" y="5265442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3C37A1C-1641-481C-8486-5148271D1C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1953" y="5265442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17E75F1-4A1A-4514-810D-5ACF457221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2537" y="5265442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AD9DEDC-3768-480D-BF7E-18CE468103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2807" y="5265442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9F37F89-7AA9-4531-8548-05E4C008D9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3391" y="5265442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E7F26B2-AD9C-4437-9713-CCC5925884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09807" y="5265442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8">
            <a:extLst>
              <a:ext uri="{FF2B5EF4-FFF2-40B4-BE49-F238E27FC236}">
                <a16:creationId xmlns:a16="http://schemas.microsoft.com/office/drawing/2014/main" id="{7C383E16-99DF-444D-9EF0-E9F1DA35D85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74933" y="1981971"/>
            <a:ext cx="0" cy="3007216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9">
            <a:extLst>
              <a:ext uri="{FF2B5EF4-FFF2-40B4-BE49-F238E27FC236}">
                <a16:creationId xmlns:a16="http://schemas.microsoft.com/office/drawing/2014/main" id="{D0A0D50D-2B56-45DE-A015-723F7CE2552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4989188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C77A438C-A903-4AE5-8E8C-6F88B27999B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4387349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E3EE4B31-E76B-42D3-B099-152C3D2CC66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3785512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08CCCCCD-CAC0-4300-9677-FE58FACA311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3185647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ADEEB41F-1496-4BD0-B1E6-C3D8D4AA2C2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2583809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8827952A-446F-4A22-8AB3-6A9A67056E3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79490" y="1981971"/>
            <a:ext cx="9544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61ECB16-DBFB-4404-8E6E-BF2F5F9044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4846348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55A7D03-7D64-40BA-A851-F50A9A0810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4244511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B42A981-C0DE-4805-9456-F3CA9B7493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3642672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D9F5170-103A-44AF-85C9-78C9D51D70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3040835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137ECA5-5B76-41B1-BE47-C9636F972A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2438996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B8683B6-8A1E-4EB8-9FB8-4FF989F94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1124" y="1839132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Freeform 31">
            <a:extLst>
              <a:ext uri="{FF2B5EF4-FFF2-40B4-BE49-F238E27FC236}">
                <a16:creationId xmlns:a16="http://schemas.microsoft.com/office/drawing/2014/main" id="{FEF05066-C50B-48C5-9E0A-CD3587E14D5E}"/>
              </a:ext>
            </a:extLst>
          </p:cNvPr>
          <p:cNvSpPr>
            <a:spLocks/>
          </p:cNvSpPr>
          <p:nvPr/>
        </p:nvSpPr>
        <p:spPr bwMode="auto">
          <a:xfrm>
            <a:off x="3974933" y="1857656"/>
            <a:ext cx="4877957" cy="3255846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Freeform 34">
            <a:extLst>
              <a:ext uri="{FF2B5EF4-FFF2-40B4-BE49-F238E27FC236}">
                <a16:creationId xmlns:a16="http://schemas.microsoft.com/office/drawing/2014/main" id="{C80CADA4-D68B-4736-8DA8-2269CECFEB9C}"/>
              </a:ext>
            </a:extLst>
          </p:cNvPr>
          <p:cNvSpPr>
            <a:spLocks/>
          </p:cNvSpPr>
          <p:nvPr/>
        </p:nvSpPr>
        <p:spPr bwMode="auto">
          <a:xfrm>
            <a:off x="4155503" y="1981971"/>
            <a:ext cx="5076582" cy="295986"/>
          </a:xfrm>
          <a:custGeom>
            <a:avLst/>
            <a:gdLst>
              <a:gd name="T0" fmla="*/ 0 w 536"/>
              <a:gd name="T1" fmla="*/ 0 h 41"/>
              <a:gd name="T2" fmla="*/ 9 w 536"/>
              <a:gd name="T3" fmla="*/ 0 h 41"/>
              <a:gd name="T4" fmla="*/ 9 w 536"/>
              <a:gd name="T5" fmla="*/ 1 h 41"/>
              <a:gd name="T6" fmla="*/ 43 w 536"/>
              <a:gd name="T7" fmla="*/ 1 h 41"/>
              <a:gd name="T8" fmla="*/ 43 w 536"/>
              <a:gd name="T9" fmla="*/ 2 h 41"/>
              <a:gd name="T10" fmla="*/ 95 w 536"/>
              <a:gd name="T11" fmla="*/ 2 h 41"/>
              <a:gd name="T12" fmla="*/ 95 w 536"/>
              <a:gd name="T13" fmla="*/ 3 h 41"/>
              <a:gd name="T14" fmla="*/ 100 w 536"/>
              <a:gd name="T15" fmla="*/ 3 h 41"/>
              <a:gd name="T16" fmla="*/ 100 w 536"/>
              <a:gd name="T17" fmla="*/ 5 h 41"/>
              <a:gd name="T18" fmla="*/ 119 w 536"/>
              <a:gd name="T19" fmla="*/ 5 h 41"/>
              <a:gd name="T20" fmla="*/ 119 w 536"/>
              <a:gd name="T21" fmla="*/ 7 h 41"/>
              <a:gd name="T22" fmla="*/ 129 w 536"/>
              <a:gd name="T23" fmla="*/ 7 h 41"/>
              <a:gd name="T24" fmla="*/ 129 w 536"/>
              <a:gd name="T25" fmla="*/ 8 h 41"/>
              <a:gd name="T26" fmla="*/ 143 w 536"/>
              <a:gd name="T27" fmla="*/ 8 h 41"/>
              <a:gd name="T28" fmla="*/ 143 w 536"/>
              <a:gd name="T29" fmla="*/ 9 h 41"/>
              <a:gd name="T30" fmla="*/ 152 w 536"/>
              <a:gd name="T31" fmla="*/ 9 h 41"/>
              <a:gd name="T32" fmla="*/ 152 w 536"/>
              <a:gd name="T33" fmla="*/ 10 h 41"/>
              <a:gd name="T34" fmla="*/ 172 w 536"/>
              <a:gd name="T35" fmla="*/ 10 h 41"/>
              <a:gd name="T36" fmla="*/ 172 w 536"/>
              <a:gd name="T37" fmla="*/ 11 h 41"/>
              <a:gd name="T38" fmla="*/ 176 w 536"/>
              <a:gd name="T39" fmla="*/ 11 h 41"/>
              <a:gd name="T40" fmla="*/ 176 w 536"/>
              <a:gd name="T41" fmla="*/ 12 h 41"/>
              <a:gd name="T42" fmla="*/ 181 w 536"/>
              <a:gd name="T43" fmla="*/ 12 h 41"/>
              <a:gd name="T44" fmla="*/ 181 w 536"/>
              <a:gd name="T45" fmla="*/ 13 h 41"/>
              <a:gd name="T46" fmla="*/ 224 w 536"/>
              <a:gd name="T47" fmla="*/ 13 h 41"/>
              <a:gd name="T48" fmla="*/ 224 w 536"/>
              <a:gd name="T49" fmla="*/ 15 h 41"/>
              <a:gd name="T50" fmla="*/ 229 w 536"/>
              <a:gd name="T51" fmla="*/ 15 h 41"/>
              <a:gd name="T52" fmla="*/ 229 w 536"/>
              <a:gd name="T53" fmla="*/ 16 h 41"/>
              <a:gd name="T54" fmla="*/ 234 w 536"/>
              <a:gd name="T55" fmla="*/ 16 h 41"/>
              <a:gd name="T56" fmla="*/ 234 w 536"/>
              <a:gd name="T57" fmla="*/ 17 h 41"/>
              <a:gd name="T58" fmla="*/ 291 w 536"/>
              <a:gd name="T59" fmla="*/ 17 h 41"/>
              <a:gd name="T60" fmla="*/ 291 w 536"/>
              <a:gd name="T61" fmla="*/ 19 h 41"/>
              <a:gd name="T62" fmla="*/ 305 w 536"/>
              <a:gd name="T63" fmla="*/ 19 h 41"/>
              <a:gd name="T64" fmla="*/ 305 w 536"/>
              <a:gd name="T65" fmla="*/ 20 h 41"/>
              <a:gd name="T66" fmla="*/ 315 w 536"/>
              <a:gd name="T67" fmla="*/ 20 h 41"/>
              <a:gd name="T68" fmla="*/ 315 w 536"/>
              <a:gd name="T69" fmla="*/ 22 h 41"/>
              <a:gd name="T70" fmla="*/ 324 w 536"/>
              <a:gd name="T71" fmla="*/ 22 h 41"/>
              <a:gd name="T72" fmla="*/ 324 w 536"/>
              <a:gd name="T73" fmla="*/ 23 h 41"/>
              <a:gd name="T74" fmla="*/ 353 w 536"/>
              <a:gd name="T75" fmla="*/ 23 h 41"/>
              <a:gd name="T76" fmla="*/ 353 w 536"/>
              <a:gd name="T77" fmla="*/ 24 h 41"/>
              <a:gd name="T78" fmla="*/ 363 w 536"/>
              <a:gd name="T79" fmla="*/ 24 h 41"/>
              <a:gd name="T80" fmla="*/ 363 w 536"/>
              <a:gd name="T81" fmla="*/ 26 h 41"/>
              <a:gd name="T82" fmla="*/ 372 w 536"/>
              <a:gd name="T83" fmla="*/ 26 h 41"/>
              <a:gd name="T84" fmla="*/ 372 w 536"/>
              <a:gd name="T85" fmla="*/ 28 h 41"/>
              <a:gd name="T86" fmla="*/ 377 w 536"/>
              <a:gd name="T87" fmla="*/ 28 h 41"/>
              <a:gd name="T88" fmla="*/ 377 w 536"/>
              <a:gd name="T89" fmla="*/ 29 h 41"/>
              <a:gd name="T90" fmla="*/ 386 w 536"/>
              <a:gd name="T91" fmla="*/ 29 h 41"/>
              <a:gd name="T92" fmla="*/ 386 w 536"/>
              <a:gd name="T93" fmla="*/ 31 h 41"/>
              <a:gd name="T94" fmla="*/ 420 w 536"/>
              <a:gd name="T95" fmla="*/ 31 h 41"/>
              <a:gd name="T96" fmla="*/ 420 w 536"/>
              <a:gd name="T97" fmla="*/ 33 h 41"/>
              <a:gd name="T98" fmla="*/ 444 w 536"/>
              <a:gd name="T99" fmla="*/ 33 h 41"/>
              <a:gd name="T100" fmla="*/ 444 w 536"/>
              <a:gd name="T101" fmla="*/ 35 h 41"/>
              <a:gd name="T102" fmla="*/ 458 w 536"/>
              <a:gd name="T103" fmla="*/ 35 h 41"/>
              <a:gd name="T104" fmla="*/ 458 w 536"/>
              <a:gd name="T105" fmla="*/ 37 h 41"/>
              <a:gd name="T106" fmla="*/ 520 w 536"/>
              <a:gd name="T107" fmla="*/ 37 h 41"/>
              <a:gd name="T108" fmla="*/ 520 w 536"/>
              <a:gd name="T109" fmla="*/ 41 h 41"/>
              <a:gd name="T110" fmla="*/ 536 w 536"/>
              <a:gd name="T111" fmla="*/ 4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536" h="41">
                <a:moveTo>
                  <a:pt x="0" y="0"/>
                </a:moveTo>
                <a:lnTo>
                  <a:pt x="9" y="0"/>
                </a:lnTo>
                <a:lnTo>
                  <a:pt x="9" y="1"/>
                </a:lnTo>
                <a:lnTo>
                  <a:pt x="43" y="1"/>
                </a:lnTo>
                <a:lnTo>
                  <a:pt x="43" y="2"/>
                </a:lnTo>
                <a:lnTo>
                  <a:pt x="95" y="2"/>
                </a:lnTo>
                <a:lnTo>
                  <a:pt x="95" y="3"/>
                </a:lnTo>
                <a:lnTo>
                  <a:pt x="100" y="3"/>
                </a:lnTo>
                <a:lnTo>
                  <a:pt x="100" y="5"/>
                </a:lnTo>
                <a:lnTo>
                  <a:pt x="119" y="5"/>
                </a:lnTo>
                <a:lnTo>
                  <a:pt x="119" y="7"/>
                </a:lnTo>
                <a:lnTo>
                  <a:pt x="129" y="7"/>
                </a:lnTo>
                <a:lnTo>
                  <a:pt x="129" y="8"/>
                </a:lnTo>
                <a:lnTo>
                  <a:pt x="143" y="8"/>
                </a:lnTo>
                <a:lnTo>
                  <a:pt x="143" y="9"/>
                </a:lnTo>
                <a:lnTo>
                  <a:pt x="152" y="9"/>
                </a:lnTo>
                <a:lnTo>
                  <a:pt x="152" y="10"/>
                </a:lnTo>
                <a:lnTo>
                  <a:pt x="172" y="10"/>
                </a:lnTo>
                <a:lnTo>
                  <a:pt x="172" y="11"/>
                </a:lnTo>
                <a:lnTo>
                  <a:pt x="176" y="11"/>
                </a:lnTo>
                <a:lnTo>
                  <a:pt x="176" y="12"/>
                </a:lnTo>
                <a:lnTo>
                  <a:pt x="181" y="12"/>
                </a:lnTo>
                <a:lnTo>
                  <a:pt x="181" y="13"/>
                </a:lnTo>
                <a:lnTo>
                  <a:pt x="224" y="13"/>
                </a:lnTo>
                <a:lnTo>
                  <a:pt x="224" y="15"/>
                </a:lnTo>
                <a:lnTo>
                  <a:pt x="229" y="15"/>
                </a:lnTo>
                <a:lnTo>
                  <a:pt x="229" y="16"/>
                </a:lnTo>
                <a:lnTo>
                  <a:pt x="234" y="16"/>
                </a:lnTo>
                <a:lnTo>
                  <a:pt x="234" y="17"/>
                </a:lnTo>
                <a:lnTo>
                  <a:pt x="291" y="17"/>
                </a:lnTo>
                <a:lnTo>
                  <a:pt x="291" y="19"/>
                </a:lnTo>
                <a:lnTo>
                  <a:pt x="305" y="19"/>
                </a:lnTo>
                <a:lnTo>
                  <a:pt x="305" y="20"/>
                </a:lnTo>
                <a:lnTo>
                  <a:pt x="315" y="20"/>
                </a:lnTo>
                <a:lnTo>
                  <a:pt x="315" y="22"/>
                </a:lnTo>
                <a:lnTo>
                  <a:pt x="324" y="22"/>
                </a:lnTo>
                <a:lnTo>
                  <a:pt x="324" y="23"/>
                </a:lnTo>
                <a:lnTo>
                  <a:pt x="353" y="23"/>
                </a:lnTo>
                <a:lnTo>
                  <a:pt x="353" y="24"/>
                </a:lnTo>
                <a:lnTo>
                  <a:pt x="363" y="24"/>
                </a:lnTo>
                <a:lnTo>
                  <a:pt x="363" y="26"/>
                </a:lnTo>
                <a:lnTo>
                  <a:pt x="372" y="26"/>
                </a:lnTo>
                <a:lnTo>
                  <a:pt x="372" y="28"/>
                </a:lnTo>
                <a:lnTo>
                  <a:pt x="377" y="28"/>
                </a:lnTo>
                <a:lnTo>
                  <a:pt x="377" y="29"/>
                </a:lnTo>
                <a:lnTo>
                  <a:pt x="386" y="29"/>
                </a:lnTo>
                <a:lnTo>
                  <a:pt x="386" y="31"/>
                </a:lnTo>
                <a:lnTo>
                  <a:pt x="420" y="31"/>
                </a:lnTo>
                <a:lnTo>
                  <a:pt x="420" y="33"/>
                </a:lnTo>
                <a:lnTo>
                  <a:pt x="444" y="33"/>
                </a:lnTo>
                <a:lnTo>
                  <a:pt x="444" y="35"/>
                </a:lnTo>
                <a:lnTo>
                  <a:pt x="458" y="35"/>
                </a:lnTo>
                <a:lnTo>
                  <a:pt x="458" y="37"/>
                </a:lnTo>
                <a:lnTo>
                  <a:pt x="520" y="37"/>
                </a:lnTo>
                <a:lnTo>
                  <a:pt x="520" y="41"/>
                </a:lnTo>
                <a:lnTo>
                  <a:pt x="536" y="41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Freeform 35">
            <a:extLst>
              <a:ext uri="{FF2B5EF4-FFF2-40B4-BE49-F238E27FC236}">
                <a16:creationId xmlns:a16="http://schemas.microsoft.com/office/drawing/2014/main" id="{2AE91305-EC5C-43D8-A5E1-5A23989E0673}"/>
              </a:ext>
            </a:extLst>
          </p:cNvPr>
          <p:cNvSpPr>
            <a:spLocks/>
          </p:cNvSpPr>
          <p:nvPr/>
        </p:nvSpPr>
        <p:spPr bwMode="auto">
          <a:xfrm>
            <a:off x="4155503" y="1981971"/>
            <a:ext cx="4385259" cy="311772"/>
          </a:xfrm>
          <a:custGeom>
            <a:avLst/>
            <a:gdLst>
              <a:gd name="T0" fmla="*/ 0 w 463"/>
              <a:gd name="T1" fmla="*/ 0 h 43"/>
              <a:gd name="T2" fmla="*/ 81 w 463"/>
              <a:gd name="T3" fmla="*/ 0 h 43"/>
              <a:gd name="T4" fmla="*/ 81 w 463"/>
              <a:gd name="T5" fmla="*/ 3 h 43"/>
              <a:gd name="T6" fmla="*/ 95 w 463"/>
              <a:gd name="T7" fmla="*/ 3 h 43"/>
              <a:gd name="T8" fmla="*/ 95 w 463"/>
              <a:gd name="T9" fmla="*/ 6 h 43"/>
              <a:gd name="T10" fmla="*/ 129 w 463"/>
              <a:gd name="T11" fmla="*/ 6 h 43"/>
              <a:gd name="T12" fmla="*/ 129 w 463"/>
              <a:gd name="T13" fmla="*/ 10 h 43"/>
              <a:gd name="T14" fmla="*/ 181 w 463"/>
              <a:gd name="T15" fmla="*/ 10 h 43"/>
              <a:gd name="T16" fmla="*/ 181 w 463"/>
              <a:gd name="T17" fmla="*/ 18 h 43"/>
              <a:gd name="T18" fmla="*/ 272 w 463"/>
              <a:gd name="T19" fmla="*/ 18 h 43"/>
              <a:gd name="T20" fmla="*/ 272 w 463"/>
              <a:gd name="T21" fmla="*/ 43 h 43"/>
              <a:gd name="T22" fmla="*/ 463 w 463"/>
              <a:gd name="T23" fmla="*/ 43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463" h="43">
                <a:moveTo>
                  <a:pt x="0" y="0"/>
                </a:moveTo>
                <a:lnTo>
                  <a:pt x="81" y="0"/>
                </a:lnTo>
                <a:lnTo>
                  <a:pt x="81" y="3"/>
                </a:lnTo>
                <a:lnTo>
                  <a:pt x="95" y="3"/>
                </a:lnTo>
                <a:lnTo>
                  <a:pt x="95" y="6"/>
                </a:lnTo>
                <a:lnTo>
                  <a:pt x="129" y="6"/>
                </a:lnTo>
                <a:lnTo>
                  <a:pt x="129" y="10"/>
                </a:lnTo>
                <a:lnTo>
                  <a:pt x="181" y="10"/>
                </a:lnTo>
                <a:lnTo>
                  <a:pt x="181" y="18"/>
                </a:lnTo>
                <a:lnTo>
                  <a:pt x="272" y="18"/>
                </a:lnTo>
                <a:lnTo>
                  <a:pt x="272" y="43"/>
                </a:lnTo>
                <a:lnTo>
                  <a:pt x="463" y="43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448A3515-0582-4657-8ABE-29A2703C6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0411" y="5662398"/>
            <a:ext cx="2964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1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8082A26-E572-4495-961A-35A8CF9360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8099" y="5662398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9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D6E8DFF-CCF7-4E15-B7FC-DE6F024725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98686" y="5662398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7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72AE1A48-1844-4630-886A-CF18FEB796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8953" y="5662398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3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410E0FA-32F8-4044-BF19-F0BFEC59B7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09540" y="5662398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39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165287B-02B4-463A-8353-98F7D4E8C3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09807" y="5662398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39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DF6AA76-807D-4323-AAF0-14264E1B26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0411" y="6010120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42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F3C91E2D-BB1D-4097-AE92-DF2AD4E966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8099" y="6010120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4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C40EED4-AEFA-4019-8695-AA16228276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2537" y="6010120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AEE3D6A-489D-4611-B5DE-0787DF1A5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2807" y="6010120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3B300F59-FD82-411F-924C-0EA9291CB3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9824" y="6010120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23F1169-F9F3-4599-8BCF-F7B6C0938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0093" y="6010120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E95ADA4-E023-4AE9-9FB4-6E1BE016AE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5484" y="5631630"/>
            <a:ext cx="43120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DR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DAEB994E-308D-4329-A796-540E05B92A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4595" y="6010120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33">
            <a:extLst>
              <a:ext uri="{FF2B5EF4-FFF2-40B4-BE49-F238E27FC236}">
                <a16:creationId xmlns:a16="http://schemas.microsoft.com/office/drawing/2014/main" id="{FB75A6BC-D8F5-41B2-BF79-A20C2E4EE17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21964" y="3335880"/>
            <a:ext cx="21555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chemical control rate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F064672-C328-4C7A-B1D7-5EF92934DC9F}"/>
              </a:ext>
            </a:extLst>
          </p:cNvPr>
          <p:cNvSpPr txBox="1"/>
          <p:nvPr/>
        </p:nvSpPr>
        <p:spPr>
          <a:xfrm>
            <a:off x="8182350" y="4634249"/>
            <a:ext cx="835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1">
            <a:extLst>
              <a:ext uri="{FF2B5EF4-FFF2-40B4-BE49-F238E27FC236}">
                <a16:creationId xmlns:a16="http://schemas.microsoft.com/office/drawing/2014/main" id="{9FBE833B-7DF7-46F9-BD43-41FFA70C786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485472" y="3704659"/>
            <a:ext cx="414729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2">
            <a:extLst>
              <a:ext uri="{FF2B5EF4-FFF2-40B4-BE49-F238E27FC236}">
                <a16:creationId xmlns:a16="http://schemas.microsoft.com/office/drawing/2014/main" id="{54AB410A-75EA-44FF-A99B-1B0D646DCDF8}"/>
              </a:ext>
            </a:extLst>
          </p:cNvPr>
          <p:cNvSpPr>
            <a:spLocks noChangeShapeType="1"/>
          </p:cNvSpPr>
          <p:nvPr/>
        </p:nvSpPr>
        <p:spPr bwMode="auto">
          <a:xfrm>
            <a:off x="6509277" y="4198350"/>
            <a:ext cx="414739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4">
            <a:extLst>
              <a:ext uri="{FF2B5EF4-FFF2-40B4-BE49-F238E27FC236}">
                <a16:creationId xmlns:a16="http://schemas.microsoft.com/office/drawing/2014/main" id="{C92B5D3E-F36A-45C7-AC41-95F1A04D9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9259" y="3548514"/>
            <a:ext cx="17088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DR</a:t>
            </a:r>
            <a:r>
              <a:rPr lang="ja-JP" altLang="en-US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notherapy 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5">
            <a:extLst>
              <a:ext uri="{FF2B5EF4-FFF2-40B4-BE49-F238E27FC236}">
                <a16:creationId xmlns:a16="http://schemas.microsoft.com/office/drawing/2014/main" id="{68D3C075-95AB-4BD3-9E66-D039D0565E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19413" y="4052576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67D5EA1-E96C-4943-AFCA-FC39DD5BC094}"/>
              </a:ext>
            </a:extLst>
          </p:cNvPr>
          <p:cNvSpPr txBox="1"/>
          <p:nvPr/>
        </p:nvSpPr>
        <p:spPr>
          <a:xfrm>
            <a:off x="4646121" y="3008839"/>
            <a:ext cx="9797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632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D91579B-0614-424C-8A0D-5DD6C925602D}"/>
              </a:ext>
            </a:extLst>
          </p:cNvPr>
          <p:cNvSpPr txBox="1"/>
          <p:nvPr/>
        </p:nvSpPr>
        <p:spPr>
          <a:xfrm>
            <a:off x="2211890" y="240040"/>
            <a:ext cx="8547164" cy="8820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 figure 1. 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iochemical control rates between UHF and BT ± EBRT.</a:t>
            </a:r>
          </a:p>
          <a:p>
            <a:pPr>
              <a:lnSpc>
                <a:spcPct val="15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) Comparison between UHF and LDR monotherapy.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24704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024D2DAD-8C60-4944-A029-7B73BCE6D5D5}"/>
              </a:ext>
            </a:extLst>
          </p:cNvPr>
          <p:cNvSpPr>
            <a:spLocks noChangeShapeType="1"/>
          </p:cNvSpPr>
          <p:nvPr/>
        </p:nvSpPr>
        <p:spPr bwMode="auto">
          <a:xfrm>
            <a:off x="4140634" y="5164348"/>
            <a:ext cx="4626184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781F59D6-CD93-4AD3-9C56-89D990036CE5}"/>
              </a:ext>
            </a:extLst>
          </p:cNvPr>
          <p:cNvSpPr>
            <a:spLocks noChangeShapeType="1"/>
          </p:cNvSpPr>
          <p:nvPr/>
        </p:nvSpPr>
        <p:spPr bwMode="auto">
          <a:xfrm>
            <a:off x="4140634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60317D33-4A85-4341-9FBF-3A25369A663C}"/>
              </a:ext>
            </a:extLst>
          </p:cNvPr>
          <p:cNvSpPr>
            <a:spLocks noChangeShapeType="1"/>
          </p:cNvSpPr>
          <p:nvPr/>
        </p:nvSpPr>
        <p:spPr bwMode="auto">
          <a:xfrm>
            <a:off x="5059534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A5E3707C-C713-4629-99A3-4F7A5716C045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1637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49EDDBF8-9FBA-4BBE-B15A-692AAA8A9854}"/>
              </a:ext>
            </a:extLst>
          </p:cNvPr>
          <p:cNvSpPr>
            <a:spLocks noChangeShapeType="1"/>
          </p:cNvSpPr>
          <p:nvPr/>
        </p:nvSpPr>
        <p:spPr bwMode="auto">
          <a:xfrm>
            <a:off x="6913176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2BF5304F-F4B9-4890-BB88-80249E8CF9D4}"/>
              </a:ext>
            </a:extLst>
          </p:cNvPr>
          <p:cNvSpPr>
            <a:spLocks noChangeShapeType="1"/>
          </p:cNvSpPr>
          <p:nvPr/>
        </p:nvSpPr>
        <p:spPr bwMode="auto">
          <a:xfrm>
            <a:off x="7845279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A4160ADB-BC25-4472-8DCD-8681BEFF3AEE}"/>
              </a:ext>
            </a:extLst>
          </p:cNvPr>
          <p:cNvSpPr>
            <a:spLocks noChangeShapeType="1"/>
          </p:cNvSpPr>
          <p:nvPr/>
        </p:nvSpPr>
        <p:spPr bwMode="auto">
          <a:xfrm>
            <a:off x="8766819" y="5164348"/>
            <a:ext cx="0" cy="6790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FE393DE-813B-49B0-8508-E737516EAF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64060" y="5322794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F3B3FD8-02D1-4BE4-B063-3714446011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5431" y="5322794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E0E91ED-8871-40A4-BE4F-5A0C8E1AFA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7532" y="5322794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44A46CB-BFD3-4C0D-825C-42CC821E3D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9073" y="5322794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EBF9332-FFF7-4391-BAC2-720C53C43D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1174" y="5322794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524DA81-1160-4E20-BFF3-1577192992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97825" y="5322794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8">
            <a:extLst>
              <a:ext uri="{FF2B5EF4-FFF2-40B4-BE49-F238E27FC236}">
                <a16:creationId xmlns:a16="http://schemas.microsoft.com/office/drawing/2014/main" id="{338A7A64-CFFF-42C2-B1A6-3A8A3F9F0FE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55798" y="1898745"/>
            <a:ext cx="0" cy="3135967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9">
            <a:extLst>
              <a:ext uri="{FF2B5EF4-FFF2-40B4-BE49-F238E27FC236}">
                <a16:creationId xmlns:a16="http://schemas.microsoft.com/office/drawing/2014/main" id="{5F99A96B-8064-4F2C-A53B-601BCB2DAA9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5034713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882A3C0E-0227-4DF9-AFA0-6CEA6147FEA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4407107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BE650EB3-4FE5-410F-BB8A-D33D95E550B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3779502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FE95F097-F39D-4555-9F2D-499B09A7E6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3153955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6A067BA6-092B-4275-8043-D7DEA4AD81B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2526349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A0AF9001-9BF4-445B-A6BE-8E2964C6F08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58100" y="1898745"/>
            <a:ext cx="977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239E4B0-69F2-489E-AF00-0C2A756395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4916159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A3B0E4D-F628-4F51-9672-CEA7383A36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4288554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6085EB3-F2C6-4EAB-9079-401AF6B37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3660949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35F8D99-5142-4D09-82B8-2BC8C5EBC6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3033344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42256B2-6420-4E62-9752-AD1753F1D6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2405739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00EAD6C-ADB8-4C96-A66E-A674770F4C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9943" y="1780191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Freeform 31">
            <a:extLst>
              <a:ext uri="{FF2B5EF4-FFF2-40B4-BE49-F238E27FC236}">
                <a16:creationId xmlns:a16="http://schemas.microsoft.com/office/drawing/2014/main" id="{872C2423-EF45-415F-8A10-A462843CB900}"/>
              </a:ext>
            </a:extLst>
          </p:cNvPr>
          <p:cNvSpPr>
            <a:spLocks/>
          </p:cNvSpPr>
          <p:nvPr/>
        </p:nvSpPr>
        <p:spPr bwMode="auto">
          <a:xfrm>
            <a:off x="3955798" y="1769108"/>
            <a:ext cx="4993217" cy="3395240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Freeform 34">
            <a:extLst>
              <a:ext uri="{FF2B5EF4-FFF2-40B4-BE49-F238E27FC236}">
                <a16:creationId xmlns:a16="http://schemas.microsoft.com/office/drawing/2014/main" id="{8C958E60-2066-4EBC-A72D-628BDCB715D2}"/>
              </a:ext>
            </a:extLst>
          </p:cNvPr>
          <p:cNvSpPr>
            <a:spLocks/>
          </p:cNvSpPr>
          <p:nvPr/>
        </p:nvSpPr>
        <p:spPr bwMode="auto">
          <a:xfrm>
            <a:off x="4140634" y="1898745"/>
            <a:ext cx="5196536" cy="362159"/>
          </a:xfrm>
          <a:custGeom>
            <a:avLst/>
            <a:gdLst>
              <a:gd name="T0" fmla="*/ 0 w 536"/>
              <a:gd name="T1" fmla="*/ 0 h 48"/>
              <a:gd name="T2" fmla="*/ 114 w 536"/>
              <a:gd name="T3" fmla="*/ 0 h 48"/>
              <a:gd name="T4" fmla="*/ 114 w 536"/>
              <a:gd name="T5" fmla="*/ 6 h 48"/>
              <a:gd name="T6" fmla="*/ 152 w 536"/>
              <a:gd name="T7" fmla="*/ 6 h 48"/>
              <a:gd name="T8" fmla="*/ 152 w 536"/>
              <a:gd name="T9" fmla="*/ 13 h 48"/>
              <a:gd name="T10" fmla="*/ 172 w 536"/>
              <a:gd name="T11" fmla="*/ 13 h 48"/>
              <a:gd name="T12" fmla="*/ 172 w 536"/>
              <a:gd name="T13" fmla="*/ 20 h 48"/>
              <a:gd name="T14" fmla="*/ 191 w 536"/>
              <a:gd name="T15" fmla="*/ 20 h 48"/>
              <a:gd name="T16" fmla="*/ 191 w 536"/>
              <a:gd name="T17" fmla="*/ 26 h 48"/>
              <a:gd name="T18" fmla="*/ 472 w 536"/>
              <a:gd name="T19" fmla="*/ 26 h 48"/>
              <a:gd name="T20" fmla="*/ 472 w 536"/>
              <a:gd name="T21" fmla="*/ 48 h 48"/>
              <a:gd name="T22" fmla="*/ 536 w 536"/>
              <a:gd name="T23" fmla="*/ 48 h 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536" h="48">
                <a:moveTo>
                  <a:pt x="0" y="0"/>
                </a:moveTo>
                <a:lnTo>
                  <a:pt x="114" y="0"/>
                </a:lnTo>
                <a:lnTo>
                  <a:pt x="114" y="6"/>
                </a:lnTo>
                <a:lnTo>
                  <a:pt x="152" y="6"/>
                </a:lnTo>
                <a:lnTo>
                  <a:pt x="152" y="13"/>
                </a:lnTo>
                <a:lnTo>
                  <a:pt x="172" y="13"/>
                </a:lnTo>
                <a:lnTo>
                  <a:pt x="172" y="20"/>
                </a:lnTo>
                <a:lnTo>
                  <a:pt x="191" y="20"/>
                </a:lnTo>
                <a:lnTo>
                  <a:pt x="191" y="26"/>
                </a:lnTo>
                <a:lnTo>
                  <a:pt x="472" y="26"/>
                </a:lnTo>
                <a:lnTo>
                  <a:pt x="472" y="48"/>
                </a:lnTo>
                <a:lnTo>
                  <a:pt x="536" y="48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Freeform 35">
            <a:extLst>
              <a:ext uri="{FF2B5EF4-FFF2-40B4-BE49-F238E27FC236}">
                <a16:creationId xmlns:a16="http://schemas.microsoft.com/office/drawing/2014/main" id="{D684B70D-FC28-47F8-8110-CF775509DEE9}"/>
              </a:ext>
            </a:extLst>
          </p:cNvPr>
          <p:cNvSpPr>
            <a:spLocks/>
          </p:cNvSpPr>
          <p:nvPr/>
        </p:nvSpPr>
        <p:spPr bwMode="auto">
          <a:xfrm>
            <a:off x="4140634" y="1898745"/>
            <a:ext cx="4121846" cy="158445"/>
          </a:xfrm>
          <a:custGeom>
            <a:avLst/>
            <a:gdLst>
              <a:gd name="T0" fmla="*/ 0 w 425"/>
              <a:gd name="T1" fmla="*/ 0 h 21"/>
              <a:gd name="T2" fmla="*/ 57 w 425"/>
              <a:gd name="T3" fmla="*/ 0 h 21"/>
              <a:gd name="T4" fmla="*/ 57 w 425"/>
              <a:gd name="T5" fmla="*/ 4 h 21"/>
              <a:gd name="T6" fmla="*/ 62 w 425"/>
              <a:gd name="T7" fmla="*/ 4 h 21"/>
              <a:gd name="T8" fmla="*/ 62 w 425"/>
              <a:gd name="T9" fmla="*/ 7 h 21"/>
              <a:gd name="T10" fmla="*/ 114 w 425"/>
              <a:gd name="T11" fmla="*/ 7 h 21"/>
              <a:gd name="T12" fmla="*/ 114 w 425"/>
              <a:gd name="T13" fmla="*/ 15 h 21"/>
              <a:gd name="T14" fmla="*/ 148 w 425"/>
              <a:gd name="T15" fmla="*/ 15 h 21"/>
              <a:gd name="T16" fmla="*/ 148 w 425"/>
              <a:gd name="T17" fmla="*/ 21 h 21"/>
              <a:gd name="T18" fmla="*/ 425 w 425"/>
              <a:gd name="T19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25" h="21">
                <a:moveTo>
                  <a:pt x="0" y="0"/>
                </a:moveTo>
                <a:lnTo>
                  <a:pt x="57" y="0"/>
                </a:lnTo>
                <a:lnTo>
                  <a:pt x="57" y="4"/>
                </a:lnTo>
                <a:lnTo>
                  <a:pt x="62" y="4"/>
                </a:lnTo>
                <a:lnTo>
                  <a:pt x="62" y="7"/>
                </a:lnTo>
                <a:lnTo>
                  <a:pt x="114" y="7"/>
                </a:lnTo>
                <a:lnTo>
                  <a:pt x="114" y="15"/>
                </a:lnTo>
                <a:lnTo>
                  <a:pt x="148" y="15"/>
                </a:lnTo>
                <a:lnTo>
                  <a:pt x="148" y="21"/>
                </a:lnTo>
                <a:lnTo>
                  <a:pt x="425" y="21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C2524B1-9BDA-4315-A3D0-BB1DA5D8E4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6531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9F851E5E-2B2F-43A7-AA82-460508141D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5431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8A76F33-4BB5-42F8-95D6-D4891A823F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7532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128DCD4C-8487-420D-9493-8A24B5E3C8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9073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8F9CA72-5E9E-402A-AB7B-37EAE0E589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21174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5B94420A-4D58-49A8-9D4E-AF249FDAC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2715" y="5712186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C2010654-4858-4FDC-920A-A40AF84249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1641" y="6089274"/>
            <a:ext cx="2850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1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762F1ED3-E90A-4F57-9BF8-DC9D035E79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0541" y="6089274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9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016E4136-2E9F-45DA-A21D-5A4E13C16C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7532" y="6089274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F1BB71C8-5797-4D0B-AA41-DA81C6190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6602" y="6089274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FEE5E6EF-8722-4BA5-A9B9-B125F9C395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8703" y="6089274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BDA8973-4213-4E8A-824C-7E94197855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0244" y="6089274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15F0D51-FAAB-4D73-B60D-A3B4C5EB2D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9396" y="5712186"/>
            <a:ext cx="119981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DR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+ EBRT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0986117-F769-4929-A233-492F43D83C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6021" y="6089273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8E9EA0A-E0F3-41B6-A9C2-585EF3CF00FD}"/>
              </a:ext>
            </a:extLst>
          </p:cNvPr>
          <p:cNvSpPr txBox="1"/>
          <p:nvPr/>
        </p:nvSpPr>
        <p:spPr>
          <a:xfrm>
            <a:off x="4591353" y="2833289"/>
            <a:ext cx="160860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71</a:t>
            </a:r>
          </a:p>
        </p:txBody>
      </p:sp>
      <p:sp>
        <p:nvSpPr>
          <p:cNvPr id="58" name="Rectangle 33">
            <a:extLst>
              <a:ext uri="{FF2B5EF4-FFF2-40B4-BE49-F238E27FC236}">
                <a16:creationId xmlns:a16="http://schemas.microsoft.com/office/drawing/2014/main" id="{F121EF54-8E37-4A04-AC8E-7D3A6897C0B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984653" y="3317641"/>
            <a:ext cx="21555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chemical control rate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19269B0-D8ED-44A0-94C7-1D2FB17A2AA4}"/>
              </a:ext>
            </a:extLst>
          </p:cNvPr>
          <p:cNvSpPr txBox="1"/>
          <p:nvPr/>
        </p:nvSpPr>
        <p:spPr>
          <a:xfrm>
            <a:off x="8317233" y="4715793"/>
            <a:ext cx="835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1">
            <a:extLst>
              <a:ext uri="{FF2B5EF4-FFF2-40B4-BE49-F238E27FC236}">
                <a16:creationId xmlns:a16="http://schemas.microsoft.com/office/drawing/2014/main" id="{3538E744-31E7-4800-8C0E-EF8AB4B9A49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268216" y="3944732"/>
            <a:ext cx="396760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2">
            <a:extLst>
              <a:ext uri="{FF2B5EF4-FFF2-40B4-BE49-F238E27FC236}">
                <a16:creationId xmlns:a16="http://schemas.microsoft.com/office/drawing/2014/main" id="{D4C9C347-866D-425B-94F5-9D04D70DAF2B}"/>
              </a:ext>
            </a:extLst>
          </p:cNvPr>
          <p:cNvSpPr>
            <a:spLocks noChangeShapeType="1"/>
          </p:cNvSpPr>
          <p:nvPr/>
        </p:nvSpPr>
        <p:spPr bwMode="auto">
          <a:xfrm>
            <a:off x="6290989" y="4318390"/>
            <a:ext cx="396770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4">
            <a:extLst>
              <a:ext uri="{FF2B5EF4-FFF2-40B4-BE49-F238E27FC236}">
                <a16:creationId xmlns:a16="http://schemas.microsoft.com/office/drawing/2014/main" id="{B6EF4307-1CD2-491F-92B8-EF1C1CB763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6602" y="3767986"/>
            <a:ext cx="119981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DR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+ EBRT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5">
            <a:extLst>
              <a:ext uri="{FF2B5EF4-FFF2-40B4-BE49-F238E27FC236}">
                <a16:creationId xmlns:a16="http://schemas.microsoft.com/office/drawing/2014/main" id="{49B6CD68-2AD6-42BC-85B0-E935424D00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4690" y="4184198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91D777B3-737F-4C7C-853A-01B95BA3EFEC}"/>
              </a:ext>
            </a:extLst>
          </p:cNvPr>
          <p:cNvSpPr txBox="1"/>
          <p:nvPr/>
        </p:nvSpPr>
        <p:spPr>
          <a:xfrm>
            <a:off x="2358015" y="168379"/>
            <a:ext cx="8262717" cy="12999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 figure 1. 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iochemical control rates between UHF and BT ± EBRT.</a:t>
            </a:r>
          </a:p>
          <a:p>
            <a:pPr marL="269240" indent="-267970" algn="just">
              <a:lnSpc>
                <a:spcPct val="15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)	Comparison between UHF and LDR + EBRT.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12298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96A4AFE7-23FB-4FF8-9A44-4A458BCC1B85}"/>
              </a:ext>
            </a:extLst>
          </p:cNvPr>
          <p:cNvSpPr>
            <a:spLocks noChangeShapeType="1"/>
          </p:cNvSpPr>
          <p:nvPr/>
        </p:nvSpPr>
        <p:spPr bwMode="auto">
          <a:xfrm>
            <a:off x="4248172" y="5044015"/>
            <a:ext cx="4520371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CAF10A8D-58D6-461F-9C55-4F6D6799CA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248172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E90BBE27-3090-4C01-B745-4E75FC25D35D}"/>
              </a:ext>
            </a:extLst>
          </p:cNvPr>
          <p:cNvSpPr>
            <a:spLocks noChangeShapeType="1"/>
          </p:cNvSpPr>
          <p:nvPr/>
        </p:nvSpPr>
        <p:spPr bwMode="auto">
          <a:xfrm>
            <a:off x="5146054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6A878897-11F0-4B99-977C-A7880C6F3230}"/>
              </a:ext>
            </a:extLst>
          </p:cNvPr>
          <p:cNvSpPr>
            <a:spLocks noChangeShapeType="1"/>
          </p:cNvSpPr>
          <p:nvPr/>
        </p:nvSpPr>
        <p:spPr bwMode="auto">
          <a:xfrm>
            <a:off x="6056837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4B21A5E5-59F3-4369-8BD6-85741362D480}"/>
              </a:ext>
            </a:extLst>
          </p:cNvPr>
          <p:cNvSpPr>
            <a:spLocks noChangeShapeType="1"/>
          </p:cNvSpPr>
          <p:nvPr/>
        </p:nvSpPr>
        <p:spPr bwMode="auto">
          <a:xfrm>
            <a:off x="6957299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54629D82-2A7E-4399-9B09-D2C55A17BEAA}"/>
              </a:ext>
            </a:extLst>
          </p:cNvPr>
          <p:cNvSpPr>
            <a:spLocks noChangeShapeType="1"/>
          </p:cNvSpPr>
          <p:nvPr/>
        </p:nvSpPr>
        <p:spPr bwMode="auto">
          <a:xfrm>
            <a:off x="7868082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29DD2DAC-A70A-4432-B95D-4207C47ACF46}"/>
              </a:ext>
            </a:extLst>
          </p:cNvPr>
          <p:cNvSpPr>
            <a:spLocks noChangeShapeType="1"/>
          </p:cNvSpPr>
          <p:nvPr/>
        </p:nvSpPr>
        <p:spPr bwMode="auto">
          <a:xfrm>
            <a:off x="8768543" y="5044015"/>
            <a:ext cx="0" cy="71631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D82C79A-56F6-4FB3-B17D-6E15BD2FDF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3350" y="5211153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B824A0A-5EB3-4FA4-B76B-E9656E5F6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4789" y="5211153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84738FE-4BC4-46CF-8CD9-0687A7BD00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5571" y="5211153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08138CF-D8A3-4485-8308-F3FA17D025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6034" y="5211153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B04DE59-CDDD-430E-8E94-591D40ECAC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6815" y="5211153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EF8B670-18F5-448F-BD08-F006877384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3415" y="5211153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8">
            <a:extLst>
              <a:ext uri="{FF2B5EF4-FFF2-40B4-BE49-F238E27FC236}">
                <a16:creationId xmlns:a16="http://schemas.microsoft.com/office/drawing/2014/main" id="{587BDCD0-2FEC-4367-BF37-8EA6999F904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67564" y="1599248"/>
            <a:ext cx="0" cy="3308019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9">
            <a:extLst>
              <a:ext uri="{FF2B5EF4-FFF2-40B4-BE49-F238E27FC236}">
                <a16:creationId xmlns:a16="http://schemas.microsoft.com/office/drawing/2014/main" id="{A809DFD5-4CF5-4A70-9745-A11D44EEFC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4907267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07327E1F-5BAA-4754-A6BB-AEC729975E7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4245228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D6C3C8D8-CF33-4428-B26C-B0AFD3C8E5D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3583191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3BBB60A2-5C35-4803-B170-4B7A571C720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2923323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E2B8C25C-26FA-4E2D-B7A7-825C6CE4FE7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2261285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FA2F4498-CBF4-4DEE-9B20-CD781542FAC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972100" y="1599248"/>
            <a:ext cx="9546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01DEFE7-8CA2-4CF0-8788-3D1767158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4772791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6DBE4C9-CB3F-44F7-9164-89E16B8DE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4110753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5C7B5564-2788-4691-86FF-11759D187D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3448715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9379DD9A-FC2B-471E-9D43-C0A2582A82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2786677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4D10FFD-F817-4A42-A8A2-3D07D61EA4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2124639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2435C20-70B9-4323-BF56-8BC995D64C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40948" y="1464771"/>
            <a:ext cx="2564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Freeform 31">
            <a:extLst>
              <a:ext uri="{FF2B5EF4-FFF2-40B4-BE49-F238E27FC236}">
                <a16:creationId xmlns:a16="http://schemas.microsoft.com/office/drawing/2014/main" id="{B8F63470-FF69-47D6-8E89-5FD8344F08C4}"/>
              </a:ext>
            </a:extLst>
          </p:cNvPr>
          <p:cNvSpPr>
            <a:spLocks/>
          </p:cNvSpPr>
          <p:nvPr/>
        </p:nvSpPr>
        <p:spPr bwMode="auto">
          <a:xfrm>
            <a:off x="4067564" y="1462498"/>
            <a:ext cx="4879008" cy="3581517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Freeform 34">
            <a:extLst>
              <a:ext uri="{FF2B5EF4-FFF2-40B4-BE49-F238E27FC236}">
                <a16:creationId xmlns:a16="http://schemas.microsoft.com/office/drawing/2014/main" id="{4FC80825-8FEC-4989-B90A-AAAFA73DDC42}"/>
              </a:ext>
            </a:extLst>
          </p:cNvPr>
          <p:cNvSpPr>
            <a:spLocks/>
          </p:cNvSpPr>
          <p:nvPr/>
        </p:nvSpPr>
        <p:spPr bwMode="auto">
          <a:xfrm>
            <a:off x="4248172" y="1599248"/>
            <a:ext cx="5077677" cy="462342"/>
          </a:xfrm>
          <a:custGeom>
            <a:avLst/>
            <a:gdLst>
              <a:gd name="T0" fmla="*/ 4 w 536"/>
              <a:gd name="T1" fmla="*/ 0 h 58"/>
              <a:gd name="T2" fmla="*/ 19 w 536"/>
              <a:gd name="T3" fmla="*/ 0 h 58"/>
              <a:gd name="T4" fmla="*/ 33 w 536"/>
              <a:gd name="T5" fmla="*/ 1 h 58"/>
              <a:gd name="T6" fmla="*/ 38 w 536"/>
              <a:gd name="T7" fmla="*/ 2 h 58"/>
              <a:gd name="T8" fmla="*/ 43 w 536"/>
              <a:gd name="T9" fmla="*/ 2 h 58"/>
              <a:gd name="T10" fmla="*/ 47 w 536"/>
              <a:gd name="T11" fmla="*/ 3 h 58"/>
              <a:gd name="T12" fmla="*/ 52 w 536"/>
              <a:gd name="T13" fmla="*/ 4 h 58"/>
              <a:gd name="T14" fmla="*/ 57 w 536"/>
              <a:gd name="T15" fmla="*/ 4 h 58"/>
              <a:gd name="T16" fmla="*/ 62 w 536"/>
              <a:gd name="T17" fmla="*/ 4 h 58"/>
              <a:gd name="T18" fmla="*/ 71 w 536"/>
              <a:gd name="T19" fmla="*/ 5 h 58"/>
              <a:gd name="T20" fmla="*/ 81 w 536"/>
              <a:gd name="T21" fmla="*/ 6 h 58"/>
              <a:gd name="T22" fmla="*/ 90 w 536"/>
              <a:gd name="T23" fmla="*/ 7 h 58"/>
              <a:gd name="T24" fmla="*/ 95 w 536"/>
              <a:gd name="T25" fmla="*/ 8 h 58"/>
              <a:gd name="T26" fmla="*/ 100 w 536"/>
              <a:gd name="T27" fmla="*/ 8 h 58"/>
              <a:gd name="T28" fmla="*/ 110 w 536"/>
              <a:gd name="T29" fmla="*/ 9 h 58"/>
              <a:gd name="T30" fmla="*/ 114 w 536"/>
              <a:gd name="T31" fmla="*/ 10 h 58"/>
              <a:gd name="T32" fmla="*/ 133 w 536"/>
              <a:gd name="T33" fmla="*/ 11 h 58"/>
              <a:gd name="T34" fmla="*/ 138 w 536"/>
              <a:gd name="T35" fmla="*/ 12 h 58"/>
              <a:gd name="T36" fmla="*/ 148 w 536"/>
              <a:gd name="T37" fmla="*/ 12 h 58"/>
              <a:gd name="T38" fmla="*/ 157 w 536"/>
              <a:gd name="T39" fmla="*/ 13 h 58"/>
              <a:gd name="T40" fmla="*/ 167 w 536"/>
              <a:gd name="T41" fmla="*/ 14 h 58"/>
              <a:gd name="T42" fmla="*/ 172 w 536"/>
              <a:gd name="T43" fmla="*/ 14 h 58"/>
              <a:gd name="T44" fmla="*/ 176 w 536"/>
              <a:gd name="T45" fmla="*/ 15 h 58"/>
              <a:gd name="T46" fmla="*/ 181 w 536"/>
              <a:gd name="T47" fmla="*/ 15 h 58"/>
              <a:gd name="T48" fmla="*/ 191 w 536"/>
              <a:gd name="T49" fmla="*/ 15 h 58"/>
              <a:gd name="T50" fmla="*/ 195 w 536"/>
              <a:gd name="T51" fmla="*/ 16 h 58"/>
              <a:gd name="T52" fmla="*/ 200 w 536"/>
              <a:gd name="T53" fmla="*/ 17 h 58"/>
              <a:gd name="T54" fmla="*/ 205 w 536"/>
              <a:gd name="T55" fmla="*/ 17 h 58"/>
              <a:gd name="T56" fmla="*/ 210 w 536"/>
              <a:gd name="T57" fmla="*/ 18 h 58"/>
              <a:gd name="T58" fmla="*/ 229 w 536"/>
              <a:gd name="T59" fmla="*/ 19 h 58"/>
              <a:gd name="T60" fmla="*/ 234 w 536"/>
              <a:gd name="T61" fmla="*/ 19 h 58"/>
              <a:gd name="T62" fmla="*/ 243 w 536"/>
              <a:gd name="T63" fmla="*/ 20 h 58"/>
              <a:gd name="T64" fmla="*/ 248 w 536"/>
              <a:gd name="T65" fmla="*/ 22 h 58"/>
              <a:gd name="T66" fmla="*/ 253 w 536"/>
              <a:gd name="T67" fmla="*/ 22 h 58"/>
              <a:gd name="T68" fmla="*/ 257 w 536"/>
              <a:gd name="T69" fmla="*/ 23 h 58"/>
              <a:gd name="T70" fmla="*/ 262 w 536"/>
              <a:gd name="T71" fmla="*/ 23 h 58"/>
              <a:gd name="T72" fmla="*/ 267 w 536"/>
              <a:gd name="T73" fmla="*/ 24 h 58"/>
              <a:gd name="T74" fmla="*/ 272 w 536"/>
              <a:gd name="T75" fmla="*/ 26 h 58"/>
              <a:gd name="T76" fmla="*/ 281 w 536"/>
              <a:gd name="T77" fmla="*/ 27 h 58"/>
              <a:gd name="T78" fmla="*/ 286 w 536"/>
              <a:gd name="T79" fmla="*/ 27 h 58"/>
              <a:gd name="T80" fmla="*/ 291 w 536"/>
              <a:gd name="T81" fmla="*/ 28 h 58"/>
              <a:gd name="T82" fmla="*/ 305 w 536"/>
              <a:gd name="T83" fmla="*/ 29 h 58"/>
              <a:gd name="T84" fmla="*/ 310 w 536"/>
              <a:gd name="T85" fmla="*/ 29 h 58"/>
              <a:gd name="T86" fmla="*/ 315 w 536"/>
              <a:gd name="T87" fmla="*/ 30 h 58"/>
              <a:gd name="T88" fmla="*/ 320 w 536"/>
              <a:gd name="T89" fmla="*/ 31 h 58"/>
              <a:gd name="T90" fmla="*/ 324 w 536"/>
              <a:gd name="T91" fmla="*/ 33 h 58"/>
              <a:gd name="T92" fmla="*/ 348 w 536"/>
              <a:gd name="T93" fmla="*/ 34 h 58"/>
              <a:gd name="T94" fmla="*/ 353 w 536"/>
              <a:gd name="T95" fmla="*/ 36 h 58"/>
              <a:gd name="T96" fmla="*/ 358 w 536"/>
              <a:gd name="T97" fmla="*/ 37 h 58"/>
              <a:gd name="T98" fmla="*/ 372 w 536"/>
              <a:gd name="T99" fmla="*/ 38 h 58"/>
              <a:gd name="T100" fmla="*/ 377 w 536"/>
              <a:gd name="T101" fmla="*/ 40 h 58"/>
              <a:gd name="T102" fmla="*/ 386 w 536"/>
              <a:gd name="T103" fmla="*/ 41 h 58"/>
              <a:gd name="T104" fmla="*/ 396 w 536"/>
              <a:gd name="T105" fmla="*/ 43 h 58"/>
              <a:gd name="T106" fmla="*/ 444 w 536"/>
              <a:gd name="T107" fmla="*/ 44 h 58"/>
              <a:gd name="T108" fmla="*/ 453 w 536"/>
              <a:gd name="T109" fmla="*/ 45 h 58"/>
              <a:gd name="T110" fmla="*/ 458 w 536"/>
              <a:gd name="T111" fmla="*/ 47 h 58"/>
              <a:gd name="T112" fmla="*/ 472 w 536"/>
              <a:gd name="T113" fmla="*/ 48 h 58"/>
              <a:gd name="T114" fmla="*/ 477 w 536"/>
              <a:gd name="T115" fmla="*/ 50 h 58"/>
              <a:gd name="T116" fmla="*/ 487 w 536"/>
              <a:gd name="T117" fmla="*/ 53 h 58"/>
              <a:gd name="T118" fmla="*/ 501 w 536"/>
              <a:gd name="T119" fmla="*/ 54 h 58"/>
              <a:gd name="T120" fmla="*/ 515 w 536"/>
              <a:gd name="T121" fmla="*/ 56 h 58"/>
              <a:gd name="T122" fmla="*/ 536 w 536"/>
              <a:gd name="T123" fmla="*/ 58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536" h="58">
                <a:moveTo>
                  <a:pt x="0" y="0"/>
                </a:moveTo>
                <a:lnTo>
                  <a:pt x="4" y="0"/>
                </a:lnTo>
                <a:lnTo>
                  <a:pt x="4" y="0"/>
                </a:lnTo>
                <a:lnTo>
                  <a:pt x="19" y="0"/>
                </a:lnTo>
                <a:lnTo>
                  <a:pt x="19" y="1"/>
                </a:lnTo>
                <a:lnTo>
                  <a:pt x="33" y="1"/>
                </a:lnTo>
                <a:lnTo>
                  <a:pt x="33" y="2"/>
                </a:lnTo>
                <a:lnTo>
                  <a:pt x="38" y="2"/>
                </a:lnTo>
                <a:lnTo>
                  <a:pt x="38" y="2"/>
                </a:lnTo>
                <a:lnTo>
                  <a:pt x="43" y="2"/>
                </a:lnTo>
                <a:lnTo>
                  <a:pt x="43" y="3"/>
                </a:lnTo>
                <a:lnTo>
                  <a:pt x="47" y="3"/>
                </a:lnTo>
                <a:lnTo>
                  <a:pt x="47" y="4"/>
                </a:lnTo>
                <a:lnTo>
                  <a:pt x="52" y="4"/>
                </a:lnTo>
                <a:lnTo>
                  <a:pt x="52" y="4"/>
                </a:lnTo>
                <a:lnTo>
                  <a:pt x="57" y="4"/>
                </a:lnTo>
                <a:lnTo>
                  <a:pt x="57" y="4"/>
                </a:lnTo>
                <a:lnTo>
                  <a:pt x="62" y="4"/>
                </a:lnTo>
                <a:lnTo>
                  <a:pt x="62" y="5"/>
                </a:lnTo>
                <a:lnTo>
                  <a:pt x="71" y="5"/>
                </a:lnTo>
                <a:lnTo>
                  <a:pt x="71" y="6"/>
                </a:lnTo>
                <a:lnTo>
                  <a:pt x="81" y="6"/>
                </a:lnTo>
                <a:lnTo>
                  <a:pt x="81" y="7"/>
                </a:lnTo>
                <a:lnTo>
                  <a:pt x="90" y="7"/>
                </a:lnTo>
                <a:lnTo>
                  <a:pt x="90" y="8"/>
                </a:lnTo>
                <a:lnTo>
                  <a:pt x="95" y="8"/>
                </a:lnTo>
                <a:lnTo>
                  <a:pt x="95" y="8"/>
                </a:lnTo>
                <a:lnTo>
                  <a:pt x="100" y="8"/>
                </a:lnTo>
                <a:lnTo>
                  <a:pt x="100" y="9"/>
                </a:lnTo>
                <a:lnTo>
                  <a:pt x="110" y="9"/>
                </a:lnTo>
                <a:lnTo>
                  <a:pt x="110" y="10"/>
                </a:lnTo>
                <a:lnTo>
                  <a:pt x="114" y="10"/>
                </a:lnTo>
                <a:lnTo>
                  <a:pt x="114" y="11"/>
                </a:lnTo>
                <a:lnTo>
                  <a:pt x="133" y="11"/>
                </a:lnTo>
                <a:lnTo>
                  <a:pt x="133" y="12"/>
                </a:lnTo>
                <a:lnTo>
                  <a:pt x="138" y="12"/>
                </a:lnTo>
                <a:lnTo>
                  <a:pt x="138" y="12"/>
                </a:lnTo>
                <a:lnTo>
                  <a:pt x="148" y="12"/>
                </a:lnTo>
                <a:lnTo>
                  <a:pt x="148" y="13"/>
                </a:lnTo>
                <a:lnTo>
                  <a:pt x="157" y="13"/>
                </a:lnTo>
                <a:lnTo>
                  <a:pt x="157" y="14"/>
                </a:lnTo>
                <a:lnTo>
                  <a:pt x="167" y="14"/>
                </a:lnTo>
                <a:lnTo>
                  <a:pt x="167" y="14"/>
                </a:lnTo>
                <a:lnTo>
                  <a:pt x="172" y="14"/>
                </a:lnTo>
                <a:lnTo>
                  <a:pt x="172" y="15"/>
                </a:lnTo>
                <a:lnTo>
                  <a:pt x="176" y="15"/>
                </a:lnTo>
                <a:lnTo>
                  <a:pt x="176" y="15"/>
                </a:lnTo>
                <a:lnTo>
                  <a:pt x="181" y="15"/>
                </a:lnTo>
                <a:lnTo>
                  <a:pt x="181" y="15"/>
                </a:lnTo>
                <a:lnTo>
                  <a:pt x="191" y="15"/>
                </a:lnTo>
                <a:lnTo>
                  <a:pt x="191" y="16"/>
                </a:lnTo>
                <a:lnTo>
                  <a:pt x="195" y="16"/>
                </a:lnTo>
                <a:lnTo>
                  <a:pt x="195" y="17"/>
                </a:lnTo>
                <a:lnTo>
                  <a:pt x="200" y="17"/>
                </a:lnTo>
                <a:lnTo>
                  <a:pt x="200" y="17"/>
                </a:lnTo>
                <a:lnTo>
                  <a:pt x="205" y="17"/>
                </a:lnTo>
                <a:lnTo>
                  <a:pt x="205" y="18"/>
                </a:lnTo>
                <a:lnTo>
                  <a:pt x="210" y="18"/>
                </a:lnTo>
                <a:lnTo>
                  <a:pt x="210" y="19"/>
                </a:lnTo>
                <a:lnTo>
                  <a:pt x="229" y="19"/>
                </a:lnTo>
                <a:lnTo>
                  <a:pt x="229" y="19"/>
                </a:lnTo>
                <a:lnTo>
                  <a:pt x="234" y="19"/>
                </a:lnTo>
                <a:lnTo>
                  <a:pt x="234" y="20"/>
                </a:lnTo>
                <a:lnTo>
                  <a:pt x="243" y="20"/>
                </a:lnTo>
                <a:lnTo>
                  <a:pt x="243" y="22"/>
                </a:lnTo>
                <a:lnTo>
                  <a:pt x="248" y="22"/>
                </a:lnTo>
                <a:lnTo>
                  <a:pt x="248" y="22"/>
                </a:lnTo>
                <a:lnTo>
                  <a:pt x="253" y="22"/>
                </a:lnTo>
                <a:lnTo>
                  <a:pt x="253" y="23"/>
                </a:lnTo>
                <a:lnTo>
                  <a:pt x="257" y="23"/>
                </a:lnTo>
                <a:lnTo>
                  <a:pt x="257" y="23"/>
                </a:lnTo>
                <a:lnTo>
                  <a:pt x="262" y="23"/>
                </a:lnTo>
                <a:lnTo>
                  <a:pt x="262" y="24"/>
                </a:lnTo>
                <a:lnTo>
                  <a:pt x="267" y="24"/>
                </a:lnTo>
                <a:lnTo>
                  <a:pt x="267" y="26"/>
                </a:lnTo>
                <a:lnTo>
                  <a:pt x="272" y="26"/>
                </a:lnTo>
                <a:lnTo>
                  <a:pt x="272" y="27"/>
                </a:lnTo>
                <a:lnTo>
                  <a:pt x="281" y="27"/>
                </a:lnTo>
                <a:lnTo>
                  <a:pt x="281" y="27"/>
                </a:lnTo>
                <a:lnTo>
                  <a:pt x="286" y="27"/>
                </a:lnTo>
                <a:lnTo>
                  <a:pt x="286" y="28"/>
                </a:lnTo>
                <a:lnTo>
                  <a:pt x="291" y="28"/>
                </a:lnTo>
                <a:lnTo>
                  <a:pt x="291" y="29"/>
                </a:lnTo>
                <a:lnTo>
                  <a:pt x="305" y="29"/>
                </a:lnTo>
                <a:lnTo>
                  <a:pt x="305" y="29"/>
                </a:lnTo>
                <a:lnTo>
                  <a:pt x="310" y="29"/>
                </a:lnTo>
                <a:lnTo>
                  <a:pt x="310" y="30"/>
                </a:lnTo>
                <a:lnTo>
                  <a:pt x="315" y="30"/>
                </a:lnTo>
                <a:lnTo>
                  <a:pt x="315" y="31"/>
                </a:lnTo>
                <a:lnTo>
                  <a:pt x="320" y="31"/>
                </a:lnTo>
                <a:lnTo>
                  <a:pt x="320" y="33"/>
                </a:lnTo>
                <a:lnTo>
                  <a:pt x="324" y="33"/>
                </a:lnTo>
                <a:lnTo>
                  <a:pt x="324" y="34"/>
                </a:lnTo>
                <a:lnTo>
                  <a:pt x="348" y="34"/>
                </a:lnTo>
                <a:lnTo>
                  <a:pt x="348" y="36"/>
                </a:lnTo>
                <a:lnTo>
                  <a:pt x="353" y="36"/>
                </a:lnTo>
                <a:lnTo>
                  <a:pt x="353" y="37"/>
                </a:lnTo>
                <a:lnTo>
                  <a:pt x="358" y="37"/>
                </a:lnTo>
                <a:lnTo>
                  <a:pt x="358" y="38"/>
                </a:lnTo>
                <a:lnTo>
                  <a:pt x="372" y="38"/>
                </a:lnTo>
                <a:lnTo>
                  <a:pt x="372" y="40"/>
                </a:lnTo>
                <a:lnTo>
                  <a:pt x="377" y="40"/>
                </a:lnTo>
                <a:lnTo>
                  <a:pt x="377" y="41"/>
                </a:lnTo>
                <a:lnTo>
                  <a:pt x="386" y="41"/>
                </a:lnTo>
                <a:lnTo>
                  <a:pt x="386" y="43"/>
                </a:lnTo>
                <a:lnTo>
                  <a:pt x="396" y="43"/>
                </a:lnTo>
                <a:lnTo>
                  <a:pt x="396" y="44"/>
                </a:lnTo>
                <a:lnTo>
                  <a:pt x="444" y="44"/>
                </a:lnTo>
                <a:lnTo>
                  <a:pt x="444" y="45"/>
                </a:lnTo>
                <a:lnTo>
                  <a:pt x="453" y="45"/>
                </a:lnTo>
                <a:lnTo>
                  <a:pt x="453" y="47"/>
                </a:lnTo>
                <a:lnTo>
                  <a:pt x="458" y="47"/>
                </a:lnTo>
                <a:lnTo>
                  <a:pt x="458" y="48"/>
                </a:lnTo>
                <a:lnTo>
                  <a:pt x="472" y="48"/>
                </a:lnTo>
                <a:lnTo>
                  <a:pt x="472" y="50"/>
                </a:lnTo>
                <a:lnTo>
                  <a:pt x="477" y="50"/>
                </a:lnTo>
                <a:lnTo>
                  <a:pt x="477" y="53"/>
                </a:lnTo>
                <a:lnTo>
                  <a:pt x="487" y="53"/>
                </a:lnTo>
                <a:lnTo>
                  <a:pt x="487" y="54"/>
                </a:lnTo>
                <a:lnTo>
                  <a:pt x="501" y="54"/>
                </a:lnTo>
                <a:lnTo>
                  <a:pt x="501" y="56"/>
                </a:lnTo>
                <a:lnTo>
                  <a:pt x="515" y="56"/>
                </a:lnTo>
                <a:lnTo>
                  <a:pt x="515" y="58"/>
                </a:lnTo>
                <a:lnTo>
                  <a:pt x="536" y="58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Freeform 35">
            <a:extLst>
              <a:ext uri="{FF2B5EF4-FFF2-40B4-BE49-F238E27FC236}">
                <a16:creationId xmlns:a16="http://schemas.microsoft.com/office/drawing/2014/main" id="{9D8B070D-26A3-490F-9FF6-A9EE506538CC}"/>
              </a:ext>
            </a:extLst>
          </p:cNvPr>
          <p:cNvSpPr>
            <a:spLocks/>
          </p:cNvSpPr>
          <p:nvPr/>
        </p:nvSpPr>
        <p:spPr bwMode="auto">
          <a:xfrm>
            <a:off x="4248172" y="1599248"/>
            <a:ext cx="4386205" cy="286521"/>
          </a:xfrm>
          <a:custGeom>
            <a:avLst/>
            <a:gdLst>
              <a:gd name="T0" fmla="*/ 0 w 463"/>
              <a:gd name="T1" fmla="*/ 0 h 36"/>
              <a:gd name="T2" fmla="*/ 57 w 463"/>
              <a:gd name="T3" fmla="*/ 0 h 36"/>
              <a:gd name="T4" fmla="*/ 57 w 463"/>
              <a:gd name="T5" fmla="*/ 1 h 36"/>
              <a:gd name="T6" fmla="*/ 62 w 463"/>
              <a:gd name="T7" fmla="*/ 1 h 36"/>
              <a:gd name="T8" fmla="*/ 62 w 463"/>
              <a:gd name="T9" fmla="*/ 3 h 36"/>
              <a:gd name="T10" fmla="*/ 81 w 463"/>
              <a:gd name="T11" fmla="*/ 3 h 36"/>
              <a:gd name="T12" fmla="*/ 81 w 463"/>
              <a:gd name="T13" fmla="*/ 5 h 36"/>
              <a:gd name="T14" fmla="*/ 95 w 463"/>
              <a:gd name="T15" fmla="*/ 5 h 36"/>
              <a:gd name="T16" fmla="*/ 95 w 463"/>
              <a:gd name="T17" fmla="*/ 6 h 36"/>
              <a:gd name="T18" fmla="*/ 114 w 463"/>
              <a:gd name="T19" fmla="*/ 6 h 36"/>
              <a:gd name="T20" fmla="*/ 114 w 463"/>
              <a:gd name="T21" fmla="*/ 10 h 36"/>
              <a:gd name="T22" fmla="*/ 129 w 463"/>
              <a:gd name="T23" fmla="*/ 10 h 36"/>
              <a:gd name="T24" fmla="*/ 129 w 463"/>
              <a:gd name="T25" fmla="*/ 12 h 36"/>
              <a:gd name="T26" fmla="*/ 148 w 463"/>
              <a:gd name="T27" fmla="*/ 12 h 36"/>
              <a:gd name="T28" fmla="*/ 148 w 463"/>
              <a:gd name="T29" fmla="*/ 15 h 36"/>
              <a:gd name="T30" fmla="*/ 181 w 463"/>
              <a:gd name="T31" fmla="*/ 15 h 36"/>
              <a:gd name="T32" fmla="*/ 181 w 463"/>
              <a:gd name="T33" fmla="*/ 20 h 36"/>
              <a:gd name="T34" fmla="*/ 272 w 463"/>
              <a:gd name="T35" fmla="*/ 20 h 36"/>
              <a:gd name="T36" fmla="*/ 272 w 463"/>
              <a:gd name="T37" fmla="*/ 36 h 36"/>
              <a:gd name="T38" fmla="*/ 463 w 463"/>
              <a:gd name="T39" fmla="*/ 36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463" h="36">
                <a:moveTo>
                  <a:pt x="0" y="0"/>
                </a:moveTo>
                <a:lnTo>
                  <a:pt x="57" y="0"/>
                </a:lnTo>
                <a:lnTo>
                  <a:pt x="57" y="1"/>
                </a:lnTo>
                <a:lnTo>
                  <a:pt x="62" y="1"/>
                </a:lnTo>
                <a:lnTo>
                  <a:pt x="62" y="3"/>
                </a:lnTo>
                <a:lnTo>
                  <a:pt x="81" y="3"/>
                </a:lnTo>
                <a:lnTo>
                  <a:pt x="81" y="5"/>
                </a:lnTo>
                <a:lnTo>
                  <a:pt x="95" y="5"/>
                </a:lnTo>
                <a:lnTo>
                  <a:pt x="95" y="6"/>
                </a:lnTo>
                <a:lnTo>
                  <a:pt x="114" y="6"/>
                </a:lnTo>
                <a:lnTo>
                  <a:pt x="114" y="10"/>
                </a:lnTo>
                <a:lnTo>
                  <a:pt x="129" y="10"/>
                </a:lnTo>
                <a:lnTo>
                  <a:pt x="129" y="12"/>
                </a:lnTo>
                <a:lnTo>
                  <a:pt x="148" y="12"/>
                </a:lnTo>
                <a:lnTo>
                  <a:pt x="148" y="15"/>
                </a:lnTo>
                <a:lnTo>
                  <a:pt x="181" y="15"/>
                </a:lnTo>
                <a:lnTo>
                  <a:pt x="181" y="20"/>
                </a:lnTo>
                <a:lnTo>
                  <a:pt x="272" y="20"/>
                </a:lnTo>
                <a:lnTo>
                  <a:pt x="272" y="36"/>
                </a:lnTo>
                <a:lnTo>
                  <a:pt x="463" y="36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3937327-C84C-4674-B1CF-CCC0AF0204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9183" y="5576786"/>
            <a:ext cx="3990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187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2904760-502C-4C6C-92E8-FB8058B435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7065" y="5576786"/>
            <a:ext cx="3990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164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4ED54DE-5F3E-4A67-8862-22755BE484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1710" y="5576786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25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1CEBFEA-30C6-4315-B603-A70905CABB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2171" y="5576786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96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2922608-94E9-4FD7-BD93-7E7F92D08F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02954" y="5576786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8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F32FF6D-BAC0-4510-8353-70254F9CF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3415" y="5576786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4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C86A4A4B-5CB1-4BD4-92E3-DC26FFC476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3045" y="5977380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3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2B66BEE-086E-403F-A666-E571B59797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0926" y="5977380"/>
            <a:ext cx="30777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998A6CF0-CE41-4C4A-85E6-FBB933B48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5571" y="5977380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1584DF0A-E05D-4859-B884-A226BD2FE4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6034" y="5977380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25172FF-2150-4563-9ADF-70A7D5BB74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46815" y="5977380"/>
            <a:ext cx="2051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ED590F9-8482-4AC7-8C74-FDBB6B705A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3720" y="5977380"/>
            <a:ext cx="1025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6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F5EC87D-F5B6-4431-A16B-388F064F1C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3814" y="5557930"/>
            <a:ext cx="122386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DR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+ EBRT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6998BED4-4961-4CD7-9FAA-FDB0926856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9249" y="5977380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EB217F3-8586-41C7-95D1-56F517DBC677}"/>
              </a:ext>
            </a:extLst>
          </p:cNvPr>
          <p:cNvSpPr txBox="1"/>
          <p:nvPr/>
        </p:nvSpPr>
        <p:spPr>
          <a:xfrm>
            <a:off x="4813754" y="3926087"/>
            <a:ext cx="12430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62</a:t>
            </a:r>
          </a:p>
        </p:txBody>
      </p:sp>
      <p:sp>
        <p:nvSpPr>
          <p:cNvPr id="58" name="Rectangle 33">
            <a:extLst>
              <a:ext uri="{FF2B5EF4-FFF2-40B4-BE49-F238E27FC236}">
                <a16:creationId xmlns:a16="http://schemas.microsoft.com/office/drawing/2014/main" id="{6B46199A-89FC-469B-8234-CDAD67664D7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83908" y="3130452"/>
            <a:ext cx="21555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ochemical control rate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CC5053B-CB29-441E-B99A-9050A833B423}"/>
              </a:ext>
            </a:extLst>
          </p:cNvPr>
          <p:cNvSpPr txBox="1"/>
          <p:nvPr/>
        </p:nvSpPr>
        <p:spPr>
          <a:xfrm>
            <a:off x="8327273" y="4626459"/>
            <a:ext cx="835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1">
            <a:extLst>
              <a:ext uri="{FF2B5EF4-FFF2-40B4-BE49-F238E27FC236}">
                <a16:creationId xmlns:a16="http://schemas.microsoft.com/office/drawing/2014/main" id="{FF60B910-A204-48BD-B7EC-A8423CA85D9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268216" y="3896606"/>
            <a:ext cx="396760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52">
            <a:extLst>
              <a:ext uri="{FF2B5EF4-FFF2-40B4-BE49-F238E27FC236}">
                <a16:creationId xmlns:a16="http://schemas.microsoft.com/office/drawing/2014/main" id="{48DF9153-C205-48ED-BBB5-C372B6CBD2F4}"/>
              </a:ext>
            </a:extLst>
          </p:cNvPr>
          <p:cNvSpPr>
            <a:spLocks noChangeShapeType="1"/>
          </p:cNvSpPr>
          <p:nvPr/>
        </p:nvSpPr>
        <p:spPr bwMode="auto">
          <a:xfrm>
            <a:off x="6290989" y="4318390"/>
            <a:ext cx="396770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54">
            <a:extLst>
              <a:ext uri="{FF2B5EF4-FFF2-40B4-BE49-F238E27FC236}">
                <a16:creationId xmlns:a16="http://schemas.microsoft.com/office/drawing/2014/main" id="{CAD89250-3E96-4943-B5B0-2EB4A733CD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1830" y="3754290"/>
            <a:ext cx="122386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6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DR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+ EBRT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5">
            <a:extLst>
              <a:ext uri="{FF2B5EF4-FFF2-40B4-BE49-F238E27FC236}">
                <a16:creationId xmlns:a16="http://schemas.microsoft.com/office/drawing/2014/main" id="{CF06B78D-D4C6-44B3-8261-6B508F2076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74690" y="4184198"/>
            <a:ext cx="4328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HF</a:t>
            </a:r>
            <a:endParaRPr kumimoji="0" lang="ja-JP" altLang="ja-JP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7B9FE7B-7191-43A7-882C-ABF579D2D92A}"/>
              </a:ext>
            </a:extLst>
          </p:cNvPr>
          <p:cNvSpPr txBox="1"/>
          <p:nvPr/>
        </p:nvSpPr>
        <p:spPr>
          <a:xfrm>
            <a:off x="2143927" y="379569"/>
            <a:ext cx="811111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 figure 1. 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iochemical control rates between UHF and BT ± EBRT.</a:t>
            </a:r>
          </a:p>
          <a:p>
            <a:pPr marL="269240" indent="-267970" algn="just">
              <a:lnSpc>
                <a:spcPct val="150000"/>
              </a:lnSpc>
            </a:pP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)  Comparison between UHF and HDR + EBRT. 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269240" indent="-267970" algn="just">
              <a:lnSpc>
                <a:spcPct val="150000"/>
              </a:lnSpc>
            </a:pP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705426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7989E2A-3B1F-43DE-854A-78CDA7331CBE}"/>
              </a:ext>
            </a:extLst>
          </p:cNvPr>
          <p:cNvGrpSpPr/>
          <p:nvPr/>
        </p:nvGrpSpPr>
        <p:grpSpPr>
          <a:xfrm>
            <a:off x="2738147" y="1796501"/>
            <a:ext cx="5462473" cy="4386768"/>
            <a:chOff x="2402588" y="880703"/>
            <a:chExt cx="5462473" cy="4386768"/>
          </a:xfrm>
        </p:grpSpPr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9FC30DEB-D801-48B2-98E2-7FED1D024D02}"/>
                </a:ext>
              </a:extLst>
            </p:cNvPr>
            <p:cNvGrpSpPr/>
            <p:nvPr/>
          </p:nvGrpSpPr>
          <p:grpSpPr>
            <a:xfrm>
              <a:off x="2402588" y="880703"/>
              <a:ext cx="5116771" cy="4386768"/>
              <a:chOff x="2454636" y="1613313"/>
              <a:chExt cx="4024355" cy="3625524"/>
            </a:xfrm>
          </p:grpSpPr>
          <p:sp>
            <p:nvSpPr>
              <p:cNvPr id="6" name="Line 5">
                <a:extLst>
                  <a:ext uri="{FF2B5EF4-FFF2-40B4-BE49-F238E27FC236}">
                    <a16:creationId xmlns:a16="http://schemas.microsoft.com/office/drawing/2014/main" id="{549C5D20-0DE8-4CCA-9FB5-17CE75C147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7224" y="4256248"/>
                <a:ext cx="27813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Line 6">
                <a:extLst>
                  <a:ext uri="{FF2B5EF4-FFF2-40B4-BE49-F238E27FC236}">
                    <a16:creationId xmlns:a16="http://schemas.microsoft.com/office/drawing/2014/main" id="{ABED177B-F32A-45AE-B88B-07631EC43E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7224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Line 7">
                <a:extLst>
                  <a:ext uri="{FF2B5EF4-FFF2-40B4-BE49-F238E27FC236}">
                    <a16:creationId xmlns:a16="http://schemas.microsoft.com/office/drawing/2014/main" id="{D80D741C-9C86-4D4E-9C54-2D11335848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09674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Line 8">
                <a:extLst>
                  <a:ext uri="{FF2B5EF4-FFF2-40B4-BE49-F238E27FC236}">
                    <a16:creationId xmlns:a16="http://schemas.microsoft.com/office/drawing/2014/main" id="{4EEBB7CD-8B0C-40C0-894E-0137840480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70062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Line 9">
                <a:extLst>
                  <a:ext uri="{FF2B5EF4-FFF2-40B4-BE49-F238E27FC236}">
                    <a16:creationId xmlns:a16="http://schemas.microsoft.com/office/drawing/2014/main" id="{7C14E9FD-FB4B-40CB-9A10-074EDDC047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24099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Line 10">
                <a:extLst>
                  <a:ext uri="{FF2B5EF4-FFF2-40B4-BE49-F238E27FC236}">
                    <a16:creationId xmlns:a16="http://schemas.microsoft.com/office/drawing/2014/main" id="{2918EDCD-E729-40C5-AA43-7598623D0A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84487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Line 11">
                <a:extLst>
                  <a:ext uri="{FF2B5EF4-FFF2-40B4-BE49-F238E27FC236}">
                    <a16:creationId xmlns:a16="http://schemas.microsoft.com/office/drawing/2014/main" id="{16E7D92F-EE09-417E-8A38-037389D472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38524" y="4256248"/>
                <a:ext cx="0" cy="523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8CDDF030-CF16-4880-BB4B-1E00CAB535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1187" y="4378486"/>
                <a:ext cx="80689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E644375F-C413-4F43-8991-4546A3B8C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35062" y="4378486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DF8D437-3A60-48D0-B54A-DA9DA372DA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449" y="4378486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8777E72E-C98F-44F4-ACCE-AB6C0D0324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9487" y="4378486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7409F343-753B-4954-9FFC-B867015F07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9874" y="4378486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77EC1761-6203-4233-80C8-A9133FBE69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6924" y="4378486"/>
                <a:ext cx="242067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Line 18">
                <a:extLst>
                  <a:ext uri="{FF2B5EF4-FFF2-40B4-BE49-F238E27FC236}">
                    <a16:creationId xmlns:a16="http://schemas.microsoft.com/office/drawing/2014/main" id="{3322B665-610C-442B-AD5C-9F58C64C85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6099" y="1736886"/>
                <a:ext cx="0" cy="241935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Line 19">
                <a:extLst>
                  <a:ext uri="{FF2B5EF4-FFF2-40B4-BE49-F238E27FC236}">
                    <a16:creationId xmlns:a16="http://schemas.microsoft.com/office/drawing/2014/main" id="{58B1169C-75C1-4471-BE26-1BB75F5BA7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4156236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Line 20">
                <a:extLst>
                  <a:ext uri="{FF2B5EF4-FFF2-40B4-BE49-F238E27FC236}">
                    <a16:creationId xmlns:a16="http://schemas.microsoft.com/office/drawing/2014/main" id="{1CD8F030-4BDB-463F-A604-4FC39699F4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3672048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Line 21">
                <a:extLst>
                  <a:ext uri="{FF2B5EF4-FFF2-40B4-BE49-F238E27FC236}">
                    <a16:creationId xmlns:a16="http://schemas.microsoft.com/office/drawing/2014/main" id="{92AD4E63-9A17-47C9-B3E5-FCB56AC47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3187861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Line 22">
                <a:extLst>
                  <a:ext uri="{FF2B5EF4-FFF2-40B4-BE49-F238E27FC236}">
                    <a16:creationId xmlns:a16="http://schemas.microsoft.com/office/drawing/2014/main" id="{10318392-C401-4EC3-B6CA-F1D8A7F47B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2705261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Line 23">
                <a:extLst>
                  <a:ext uri="{FF2B5EF4-FFF2-40B4-BE49-F238E27FC236}">
                    <a16:creationId xmlns:a16="http://schemas.microsoft.com/office/drawing/2014/main" id="{110B0E81-E6F4-4EE7-9780-CFC304D2E4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2221073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Line 24">
                <a:extLst>
                  <a:ext uri="{FF2B5EF4-FFF2-40B4-BE49-F238E27FC236}">
                    <a16:creationId xmlns:a16="http://schemas.microsoft.com/office/drawing/2014/main" id="{F6D18EAE-1812-46D5-9957-27246DE19F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87362" y="1736886"/>
                <a:ext cx="587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CD60B9F6-179A-4F76-8712-5BC4073008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4032663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AECA77A4-1B63-4394-BEBD-5315CC4218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3548476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CF2F0083-5FA9-4867-9B02-C355350452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3064288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EED3C428-C0B9-4CAD-BBF4-DBF5030952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2580101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214AADD3-E49F-4127-8662-DEFBB01314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2095913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DDE45B92-1D7D-4F86-BB74-CB71D2E915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95280" y="1613313"/>
                <a:ext cx="201722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Freeform 31">
                <a:extLst>
                  <a:ext uri="{FF2B5EF4-FFF2-40B4-BE49-F238E27FC236}">
                    <a16:creationId xmlns:a16="http://schemas.microsoft.com/office/drawing/2014/main" id="{BA5FCA17-356D-4A67-84CD-C19C1EE79C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46099" y="1636873"/>
                <a:ext cx="3001963" cy="2619375"/>
              </a:xfrm>
              <a:custGeom>
                <a:avLst/>
                <a:gdLst>
                  <a:gd name="T0" fmla="*/ 0 w 515"/>
                  <a:gd name="T1" fmla="*/ 0 h 449"/>
                  <a:gd name="T2" fmla="*/ 0 w 515"/>
                  <a:gd name="T3" fmla="*/ 449 h 449"/>
                  <a:gd name="T4" fmla="*/ 515 w 515"/>
                  <a:gd name="T5" fmla="*/ 449 h 4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5" h="449">
                    <a:moveTo>
                      <a:pt x="0" y="0"/>
                    </a:moveTo>
                    <a:lnTo>
                      <a:pt x="0" y="449"/>
                    </a:lnTo>
                    <a:lnTo>
                      <a:pt x="515" y="449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Freeform 35">
                <a:extLst>
                  <a:ext uri="{FF2B5EF4-FFF2-40B4-BE49-F238E27FC236}">
                    <a16:creationId xmlns:a16="http://schemas.microsoft.com/office/drawing/2014/main" id="{E8A532E6-6178-491A-8D45-C82DE9408E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57224" y="1736886"/>
                <a:ext cx="2139950" cy="215900"/>
              </a:xfrm>
              <a:custGeom>
                <a:avLst/>
                <a:gdLst>
                  <a:gd name="T0" fmla="*/ 0 w 367"/>
                  <a:gd name="T1" fmla="*/ 0 h 37"/>
                  <a:gd name="T2" fmla="*/ 62 w 367"/>
                  <a:gd name="T3" fmla="*/ 0 h 37"/>
                  <a:gd name="T4" fmla="*/ 62 w 367"/>
                  <a:gd name="T5" fmla="*/ 4 h 37"/>
                  <a:gd name="T6" fmla="*/ 95 w 367"/>
                  <a:gd name="T7" fmla="*/ 4 h 37"/>
                  <a:gd name="T8" fmla="*/ 95 w 367"/>
                  <a:gd name="T9" fmla="*/ 9 h 37"/>
                  <a:gd name="T10" fmla="*/ 114 w 367"/>
                  <a:gd name="T11" fmla="*/ 9 h 37"/>
                  <a:gd name="T12" fmla="*/ 114 w 367"/>
                  <a:gd name="T13" fmla="*/ 14 h 37"/>
                  <a:gd name="T14" fmla="*/ 129 w 367"/>
                  <a:gd name="T15" fmla="*/ 14 h 37"/>
                  <a:gd name="T16" fmla="*/ 129 w 367"/>
                  <a:gd name="T17" fmla="*/ 19 h 37"/>
                  <a:gd name="T18" fmla="*/ 148 w 367"/>
                  <a:gd name="T19" fmla="*/ 19 h 37"/>
                  <a:gd name="T20" fmla="*/ 148 w 367"/>
                  <a:gd name="T21" fmla="*/ 26 h 37"/>
                  <a:gd name="T22" fmla="*/ 181 w 367"/>
                  <a:gd name="T23" fmla="*/ 26 h 37"/>
                  <a:gd name="T24" fmla="*/ 181 w 367"/>
                  <a:gd name="T25" fmla="*/ 37 h 37"/>
                  <a:gd name="T26" fmla="*/ 367 w 367"/>
                  <a:gd name="T27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67" h="37">
                    <a:moveTo>
                      <a:pt x="0" y="0"/>
                    </a:moveTo>
                    <a:lnTo>
                      <a:pt x="62" y="0"/>
                    </a:lnTo>
                    <a:lnTo>
                      <a:pt x="62" y="4"/>
                    </a:lnTo>
                    <a:lnTo>
                      <a:pt x="95" y="4"/>
                    </a:lnTo>
                    <a:lnTo>
                      <a:pt x="95" y="9"/>
                    </a:lnTo>
                    <a:lnTo>
                      <a:pt x="114" y="9"/>
                    </a:lnTo>
                    <a:lnTo>
                      <a:pt x="114" y="14"/>
                    </a:lnTo>
                    <a:lnTo>
                      <a:pt x="129" y="14"/>
                    </a:lnTo>
                    <a:lnTo>
                      <a:pt x="129" y="19"/>
                    </a:lnTo>
                    <a:lnTo>
                      <a:pt x="148" y="19"/>
                    </a:lnTo>
                    <a:lnTo>
                      <a:pt x="148" y="26"/>
                    </a:lnTo>
                    <a:lnTo>
                      <a:pt x="181" y="26"/>
                    </a:lnTo>
                    <a:lnTo>
                      <a:pt x="181" y="37"/>
                    </a:lnTo>
                    <a:lnTo>
                      <a:pt x="367" y="37"/>
                    </a:lnTo>
                  </a:path>
                </a:pathLst>
              </a:custGeom>
              <a:noFill/>
              <a:ln w="285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Freeform 36">
                <a:extLst>
                  <a:ext uri="{FF2B5EF4-FFF2-40B4-BE49-F238E27FC236}">
                    <a16:creationId xmlns:a16="http://schemas.microsoft.com/office/drawing/2014/main" id="{2D63F997-D781-4AE7-9BD0-768B01B4AD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57224" y="1736886"/>
                <a:ext cx="2698750" cy="185738"/>
              </a:xfrm>
              <a:custGeom>
                <a:avLst/>
                <a:gdLst>
                  <a:gd name="T0" fmla="*/ 0 w 463"/>
                  <a:gd name="T1" fmla="*/ 0 h 32"/>
                  <a:gd name="T2" fmla="*/ 57 w 463"/>
                  <a:gd name="T3" fmla="*/ 0 h 32"/>
                  <a:gd name="T4" fmla="*/ 57 w 463"/>
                  <a:gd name="T5" fmla="*/ 2 h 32"/>
                  <a:gd name="T6" fmla="*/ 81 w 463"/>
                  <a:gd name="T7" fmla="*/ 2 h 32"/>
                  <a:gd name="T8" fmla="*/ 81 w 463"/>
                  <a:gd name="T9" fmla="*/ 5 h 32"/>
                  <a:gd name="T10" fmla="*/ 114 w 463"/>
                  <a:gd name="T11" fmla="*/ 5 h 32"/>
                  <a:gd name="T12" fmla="*/ 114 w 463"/>
                  <a:gd name="T13" fmla="*/ 8 h 32"/>
                  <a:gd name="T14" fmla="*/ 272 w 463"/>
                  <a:gd name="T15" fmla="*/ 8 h 32"/>
                  <a:gd name="T16" fmla="*/ 272 w 463"/>
                  <a:gd name="T17" fmla="*/ 32 h 32"/>
                  <a:gd name="T18" fmla="*/ 463 w 463"/>
                  <a:gd name="T19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463" h="32">
                    <a:moveTo>
                      <a:pt x="0" y="0"/>
                    </a:moveTo>
                    <a:lnTo>
                      <a:pt x="57" y="0"/>
                    </a:lnTo>
                    <a:lnTo>
                      <a:pt x="57" y="2"/>
                    </a:lnTo>
                    <a:lnTo>
                      <a:pt x="81" y="2"/>
                    </a:lnTo>
                    <a:lnTo>
                      <a:pt x="81" y="5"/>
                    </a:lnTo>
                    <a:lnTo>
                      <a:pt x="114" y="5"/>
                    </a:lnTo>
                    <a:lnTo>
                      <a:pt x="114" y="8"/>
                    </a:lnTo>
                    <a:lnTo>
                      <a:pt x="272" y="8"/>
                    </a:lnTo>
                    <a:lnTo>
                      <a:pt x="272" y="32"/>
                    </a:lnTo>
                    <a:lnTo>
                      <a:pt x="463" y="32"/>
                    </a:lnTo>
                  </a:path>
                </a:pathLst>
              </a:custGeom>
              <a:noFill/>
              <a:ln w="28575" cap="rnd">
                <a:solidFill>
                  <a:srgbClr val="00B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E26533C8-FEE8-4973-B1E1-63550317AC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2612" y="4697722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1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8138D63B-E6B4-430D-B012-3202A68783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35062" y="4697722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5064C409-4DD4-4DBB-9AA8-107F285C6F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449" y="4697722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2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BB3E5C27-A428-4B2B-8AF3-957594917C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8062" y="4697722"/>
                <a:ext cx="80689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11114AB7-39C9-4023-979D-D7E5F6EFE7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8449" y="4697722"/>
                <a:ext cx="80689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6A1085B9-09A3-42D6-AE7F-E5D85A2DA1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2487" y="4697722"/>
                <a:ext cx="80689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11DF942F-558A-41B1-AE4D-44BE724CF2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5624" y="5035343"/>
                <a:ext cx="242067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2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C9BC57DC-790E-4F97-B5E0-FD52029D11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8074" y="5035343"/>
                <a:ext cx="242067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0FC2C7F2-7B95-4F8E-821F-044570B505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449" y="5035343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ABD28906-D82D-4FC1-8262-02CFD79015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9487" y="5035343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DF39A12C-8622-41E5-BF7B-12D6521916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9874" y="5035343"/>
                <a:ext cx="161378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4D6DBC43-F275-429F-B08E-F732BC9E8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2487" y="5035343"/>
                <a:ext cx="80689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ja-JP" altLang="ja-JP" sz="16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63324C61-C626-4465-BFA8-AB98A4A492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54636" y="4697721"/>
                <a:ext cx="520697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-</a:t>
                </a:r>
                <a:r>
                  <a:rPr kumimoji="0" lang="en-US" altLang="ja-JP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HF</a:t>
                </a:r>
                <a:endParaRPr kumimoji="0" lang="ja-JP" altLang="ja-JP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BBB23EBE-9C78-4D8E-AFCA-418D1E6679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8682" y="5035343"/>
                <a:ext cx="501785" cy="203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-UHF</a:t>
                </a:r>
                <a:endParaRPr kumimoji="0" lang="ja-JP" altLang="ja-JP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Line 52">
              <a:extLst>
                <a:ext uri="{FF2B5EF4-FFF2-40B4-BE49-F238E27FC236}">
                  <a16:creationId xmlns:a16="http://schemas.microsoft.com/office/drawing/2014/main" id="{446D091A-A759-476F-818D-0C4E92F00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4512" y="2214449"/>
              <a:ext cx="161925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Line 53">
              <a:extLst>
                <a:ext uri="{FF2B5EF4-FFF2-40B4-BE49-F238E27FC236}">
                  <a16:creationId xmlns:a16="http://schemas.microsoft.com/office/drawing/2014/main" id="{AF65C0D2-C952-4D30-9994-121CDB068E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95732" y="2515965"/>
              <a:ext cx="161925" cy="0"/>
            </a:xfrm>
            <a:prstGeom prst="line">
              <a:avLst/>
            </a:prstGeom>
            <a:noFill/>
            <a:ln w="28575" cap="rnd">
              <a:solidFill>
                <a:srgbClr val="00B0F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DEA76D89-8ADA-4525-AA1A-5F9ACDFB51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36303" y="2091339"/>
              <a:ext cx="6620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-</a:t>
              </a:r>
              <a:r>
                <a:rPr kumimoji="0" lang="en-US" altLang="ja-JP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HF</a:t>
              </a:r>
              <a:endParaRPr kumimoji="0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D6F62562-6DC6-4F76-BCF1-A0E89BCAC0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41512" y="2392855"/>
              <a:ext cx="63799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6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UHF</a:t>
              </a:r>
              <a:endParaRPr kumimoji="0" lang="ja-JP" altLang="ja-JP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33">
              <a:extLst>
                <a:ext uri="{FF2B5EF4-FFF2-40B4-BE49-F238E27FC236}">
                  <a16:creationId xmlns:a16="http://schemas.microsoft.com/office/drawing/2014/main" id="{A60D7BFA-B923-49D6-8BE4-B2A6677D833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35362" y="2398385"/>
              <a:ext cx="241957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chemical control rate</a:t>
              </a:r>
              <a:endParaRPr kumimoji="0" lang="ja-JP" altLang="ja-JP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0921BB6C-BB54-4371-AEB0-41DAF2A04C80}"/>
                </a:ext>
              </a:extLst>
            </p:cNvPr>
            <p:cNvSpPr txBox="1"/>
            <p:nvPr/>
          </p:nvSpPr>
          <p:spPr>
            <a:xfrm>
              <a:off x="6949426" y="3653943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01D58EFF-B2E9-4432-AC09-DAC6A6818DF9}"/>
                </a:ext>
              </a:extLst>
            </p:cNvPr>
            <p:cNvSpPr txBox="1"/>
            <p:nvPr/>
          </p:nvSpPr>
          <p:spPr>
            <a:xfrm>
              <a:off x="4183693" y="3276145"/>
              <a:ext cx="1079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139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08D60DD-34DA-4B13-A414-103B846EE7EF}"/>
              </a:ext>
            </a:extLst>
          </p:cNvPr>
          <p:cNvSpPr txBox="1"/>
          <p:nvPr/>
        </p:nvSpPr>
        <p:spPr>
          <a:xfrm>
            <a:off x="1742174" y="247326"/>
            <a:ext cx="8917352" cy="8727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 figure 1. </a:t>
            </a:r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iochemical control rates between UHF and BT ± EBRT.</a:t>
            </a:r>
          </a:p>
          <a:p>
            <a:pPr marL="269240" indent="-267970" algn="just">
              <a:lnSpc>
                <a:spcPct val="150000"/>
              </a:lnSpc>
            </a:pP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 Comparison between H-UHF and L-UHF. 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7753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247</Words>
  <Application>Microsoft Office PowerPoint</Application>
  <PresentationFormat>ワイド画面</PresentationFormat>
  <Paragraphs>13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Hewlett-Packard Company</cp:lastModifiedBy>
  <cp:revision>52</cp:revision>
  <cp:lastPrinted>2021-11-20T08:25:21Z</cp:lastPrinted>
  <dcterms:created xsi:type="dcterms:W3CDTF">2021-11-06T04:56:22Z</dcterms:created>
  <dcterms:modified xsi:type="dcterms:W3CDTF">2022-03-11T09:38:53Z</dcterms:modified>
</cp:coreProperties>
</file>